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1" r:id="rId3"/>
    <p:sldId id="262" r:id="rId4"/>
    <p:sldId id="259" r:id="rId5"/>
    <p:sldId id="260" r:id="rId6"/>
    <p:sldId id="257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691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9F1C56-8736-3D72-2E4E-F4228B59DB1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0571B8D-AA7E-3C75-8857-040AE9333BF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2B7CAD-618C-C415-14F7-A53AE6427E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789E0-25E9-4D83-B9C2-A63509EEE98E}" type="datetimeFigureOut">
              <a:rPr lang="en-IN" smtClean="0"/>
              <a:t>23-12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CFE462-1554-928F-6A96-A37F63AD1E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4A63BE-930C-4B69-9015-8CECFD7D11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EFA6C-E473-4291-B592-C1B59B4BD51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2947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12FDDA-184E-2504-B50A-E7A76E9F7F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6ED2C1A-8641-8CA5-48A9-57D9DB5C0D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8464CA-F536-B9F5-4D2E-09292E3BF1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789E0-25E9-4D83-B9C2-A63509EEE98E}" type="datetimeFigureOut">
              <a:rPr lang="en-IN" smtClean="0"/>
              <a:t>23-12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CE646C-0657-9368-F24B-C2608926AE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11F637-16C6-C2B7-4DBD-BA2C376F26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EFA6C-E473-4291-B592-C1B59B4BD51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460690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A6D8F1E-94B4-8635-74D7-9E0BF053D80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3F64FD0-B49E-8D6C-E9C9-DC587790EA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E12F9B-B17D-5981-91D5-8F6B209334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789E0-25E9-4D83-B9C2-A63509EEE98E}" type="datetimeFigureOut">
              <a:rPr lang="en-IN" smtClean="0"/>
              <a:t>23-12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971B5E-5BD2-D095-EB92-CDB8F837F7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A3B93E-C092-273F-3016-D8C70F8165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EFA6C-E473-4291-B592-C1B59B4BD51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162652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B17F75-846A-144A-7A82-2F1BA71086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725000-3B16-A596-AF54-D23D821A281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2DCE05-AA35-59D0-55CA-5B4E4001F9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789E0-25E9-4D83-B9C2-A63509EEE98E}" type="datetimeFigureOut">
              <a:rPr lang="en-IN" smtClean="0"/>
              <a:t>23-12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BFE533-26AF-24B6-F19B-2CC359E590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719D22-DBCA-3331-BB98-26C29E4366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EFA6C-E473-4291-B592-C1B59B4BD51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490424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8B3F04-772F-09AC-E1AC-49FD9734FF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08D2AF-C976-25AC-6627-AA822C6489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E51F5A-EF5C-75E9-B4A3-C40980C8D6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789E0-25E9-4D83-B9C2-A63509EEE98E}" type="datetimeFigureOut">
              <a:rPr lang="en-IN" smtClean="0"/>
              <a:t>23-12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48067C-5B6F-4F36-1D36-FFF37F50EB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E9E4A7-16D2-B126-2DCF-495D0B1F48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EFA6C-E473-4291-B592-C1B59B4BD51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603301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84617D-2856-EA1B-C19D-39C274680C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29F10D-13B4-3469-151C-83BCBA88F3B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374F63D-F1F0-11AA-7872-61EBD34BE2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D5456C-C389-71F2-9A6D-9525B44059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789E0-25E9-4D83-B9C2-A63509EEE98E}" type="datetimeFigureOut">
              <a:rPr lang="en-IN" smtClean="0"/>
              <a:t>23-12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9197DCB-706B-B84A-7D8A-9329768223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BE13802-80FC-1627-6D73-65AA7D32D1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EFA6C-E473-4291-B592-C1B59B4BD51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50031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EF2EC6-8329-098E-066E-59740F0EFF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C45C58-C715-2549-FEB0-D2C4E25C6A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9D928B6-650B-E7EF-4A6A-87B3CFFB9D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32A1F0B-7297-1A6D-FED0-66B298BC013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A8899F3-A5C4-8732-F068-818F98E99AF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02D1479-C72C-9197-3E69-C98D50C6D7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789E0-25E9-4D83-B9C2-A63509EEE98E}" type="datetimeFigureOut">
              <a:rPr lang="en-IN" smtClean="0"/>
              <a:t>23-12-2022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C81DA6A-4FA3-7567-BF87-82F46EBBEC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7218B15-B358-536B-D7CE-956CF054E2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EFA6C-E473-4291-B592-C1B59B4BD51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554719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EC96F2-C26B-836E-EF6D-A924F91AA7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C5B4D6B-7EEB-EF1E-5639-303E488922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789E0-25E9-4D83-B9C2-A63509EEE98E}" type="datetimeFigureOut">
              <a:rPr lang="en-IN" smtClean="0"/>
              <a:t>23-12-2022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2E91F10-BC08-1C6F-4C20-EA1D2F915F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0D98C3A-3B3C-D264-3C1D-22AAD9A48F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EFA6C-E473-4291-B592-C1B59B4BD51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958303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9529FD8-0076-3A6B-0961-21AA273DD6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789E0-25E9-4D83-B9C2-A63509EEE98E}" type="datetimeFigureOut">
              <a:rPr lang="en-IN" smtClean="0"/>
              <a:t>23-12-2022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8BCEC9D-1457-5771-F9CF-EDCF1CEC7F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6F68C8C-5AB1-A121-6E23-0AAB982647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EFA6C-E473-4291-B592-C1B59B4BD51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15795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2E7BBD-67A0-10D0-5D4A-79E34DA18A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ECB92D-8EEB-5A94-C959-6EC9B2AFA4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43F4A83-9F67-A91A-1E08-CB911CACF4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0770A1-AEA8-7D93-BCE6-14EFA2D341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789E0-25E9-4D83-B9C2-A63509EEE98E}" type="datetimeFigureOut">
              <a:rPr lang="en-IN" smtClean="0"/>
              <a:t>23-12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28A3CE7-4D54-CA69-F35F-5826265B48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31F896C-FC69-99FA-2697-F5863A5954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EFA6C-E473-4291-B592-C1B59B4BD51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000321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AC2004-0BF0-7E0B-6607-02C1CCE55A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99E4BA4-C5C1-0774-4EE6-7981C313B51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55D800B-8C7B-8698-6B5A-F400BC58512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3D8D109-BF75-5A10-28A4-B8BC5480C3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789E0-25E9-4D83-B9C2-A63509EEE98E}" type="datetimeFigureOut">
              <a:rPr lang="en-IN" smtClean="0"/>
              <a:t>23-12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534A7D-FAFC-F90C-8979-24F799C57E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B137340-1990-874C-CB1D-1ACD60504A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EFA6C-E473-4291-B592-C1B59B4BD51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050361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6C7BEC8-A7CA-0E3A-171C-209217380D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34025C-0EF1-1A39-33C9-0FB5AB15FD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EE13D9-10C9-B9B2-B1CB-ABF566EC93F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9789E0-25E9-4D83-B9C2-A63509EEE98E}" type="datetimeFigureOut">
              <a:rPr lang="en-IN" smtClean="0"/>
              <a:t>23-12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CB9516-2F22-D374-AC25-6D8C26BF865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AF70FB-3839-E8D4-196A-C61E0A4B5A3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5EFA6C-E473-4291-B592-C1B59B4BD51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718208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eg"/><Relationship Id="rId3" Type="http://schemas.openxmlformats.org/officeDocument/2006/relationships/image" Target="../media/image2.png"/><Relationship Id="rId7" Type="http://schemas.microsoft.com/office/2007/relationships/hdphoto" Target="../media/hdphoto2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jpe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Relationship Id="rId5" Type="http://schemas.microsoft.com/office/2007/relationships/hdphoto" Target="../media/hdphoto3.wdp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jpeg"/><Relationship Id="rId4" Type="http://schemas.openxmlformats.org/officeDocument/2006/relationships/image" Target="../media/image3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0">
            <a:extLst>
              <a:ext uri="{FF2B5EF4-FFF2-40B4-BE49-F238E27FC236}">
                <a16:creationId xmlns:a16="http://schemas.microsoft.com/office/drawing/2014/main" id="{2AEA4BBA-6C6D-98DC-AEB0-2B3829C9C8B6}"/>
              </a:ext>
            </a:extLst>
          </p:cNvPr>
          <p:cNvGrpSpPr/>
          <p:nvPr/>
        </p:nvGrpSpPr>
        <p:grpSpPr>
          <a:xfrm>
            <a:off x="1644860" y="419869"/>
            <a:ext cx="7477430" cy="2762310"/>
            <a:chOff x="2769147" y="336280"/>
            <a:chExt cx="7739313" cy="2988304"/>
          </a:xfrm>
        </p:grpSpPr>
        <p:pic>
          <p:nvPicPr>
            <p:cNvPr id="1026" name="Picture 2" descr="F:\Shyam pERK_LXR_pJNK_pp38_18_08_2018\Shyam_pERK_30s_inc 2018.08.18_08.43.01_Ch\Shyam_pERK_30s_inc 2018.08.18_08.43.01_Ch+Marker.jpg"/>
            <p:cNvPicPr>
              <a:picLocks noChangeAspect="1" noChangeArrowheads="1"/>
            </p:cNvPicPr>
            <p:nvPr/>
          </p:nvPicPr>
          <p:blipFill rotWithShape="1">
            <a:blip r:embed="rId2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550" t="34767" r="50000" b="39065"/>
            <a:stretch/>
          </p:blipFill>
          <p:spPr bwMode="auto">
            <a:xfrm>
              <a:off x="3925066" y="775951"/>
              <a:ext cx="1528559" cy="254863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3" name="Group 22"/>
            <p:cNvGrpSpPr/>
            <p:nvPr/>
          </p:nvGrpSpPr>
          <p:grpSpPr>
            <a:xfrm>
              <a:off x="6090773" y="344714"/>
              <a:ext cx="1960479" cy="2941482"/>
              <a:chOff x="3002300" y="3539741"/>
              <a:chExt cx="1960479" cy="2941482"/>
            </a:xfrm>
          </p:grpSpPr>
          <p:pic>
            <p:nvPicPr>
              <p:cNvPr id="1030" name="Picture 6" descr="F:\Shyam ERK_tubulin_ACAT2_8_19_08_2018 -\Shyama_tubulinERK20S 2018.08.19_07.07.19_Ch\Shyama_tubulinERK20S 2018.08.19_07.07.19_Ch+Marker.jpg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grayscl/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144" t="48789" r="52056" b="25779"/>
              <a:stretch/>
            </p:blipFill>
            <p:spPr bwMode="auto">
              <a:xfrm>
                <a:off x="3002300" y="4031577"/>
                <a:ext cx="1528559" cy="244964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5" name="TextBox 14"/>
              <p:cNvSpPr txBox="1"/>
              <p:nvPr/>
            </p:nvSpPr>
            <p:spPr>
              <a:xfrm>
                <a:off x="4444793" y="4946432"/>
                <a:ext cx="517986" cy="2996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ERK</a:t>
                </a: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3178776" y="3760232"/>
                <a:ext cx="1390697" cy="2996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0       10    100</a:t>
                </a: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3388391" y="3539741"/>
                <a:ext cx="1166711" cy="2996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DLc</a:t>
                </a: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g</a:t>
                </a: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/ml)</a:t>
                </a:r>
              </a:p>
            </p:txBody>
          </p:sp>
        </p:grpSp>
        <p:grpSp>
          <p:nvGrpSpPr>
            <p:cNvPr id="7" name="Group 6"/>
            <p:cNvGrpSpPr/>
            <p:nvPr/>
          </p:nvGrpSpPr>
          <p:grpSpPr>
            <a:xfrm>
              <a:off x="2769147" y="336280"/>
              <a:ext cx="3212014" cy="2329570"/>
              <a:chOff x="1864781" y="357456"/>
              <a:chExt cx="3212014" cy="2329570"/>
            </a:xfrm>
          </p:grpSpPr>
          <p:sp>
            <p:nvSpPr>
              <p:cNvPr id="11" name="TextBox 10"/>
              <p:cNvSpPr txBox="1"/>
              <p:nvPr/>
            </p:nvSpPr>
            <p:spPr>
              <a:xfrm>
                <a:off x="3211434" y="578484"/>
                <a:ext cx="1390697" cy="2996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0       10    100</a:t>
                </a: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3463183" y="357456"/>
                <a:ext cx="1166711" cy="2996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DLc</a:t>
                </a: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g</a:t>
                </a: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/ml)</a:t>
                </a:r>
              </a:p>
            </p:txBody>
          </p:sp>
          <p:sp>
            <p:nvSpPr>
              <p:cNvPr id="4" name="TextBox 3"/>
              <p:cNvSpPr txBox="1"/>
              <p:nvPr/>
            </p:nvSpPr>
            <p:spPr>
              <a:xfrm>
                <a:off x="4470875" y="1698132"/>
                <a:ext cx="605920" cy="2996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ERK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2538703" y="1316817"/>
                <a:ext cx="550310" cy="2996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SA</a:t>
                </a: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1864781" y="2387365"/>
                <a:ext cx="1157562" cy="2996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hymotrypsin</a:t>
                </a:r>
              </a:p>
            </p:txBody>
          </p:sp>
        </p:grpSp>
        <p:grpSp>
          <p:nvGrpSpPr>
            <p:cNvPr id="2" name="Group 1"/>
            <p:cNvGrpSpPr/>
            <p:nvPr/>
          </p:nvGrpSpPr>
          <p:grpSpPr>
            <a:xfrm>
              <a:off x="8200018" y="394068"/>
              <a:ext cx="2308442" cy="2892128"/>
              <a:chOff x="7010400" y="657098"/>
              <a:chExt cx="2308442" cy="2892128"/>
            </a:xfrm>
          </p:grpSpPr>
          <p:pic>
            <p:nvPicPr>
              <p:cNvPr id="34" name="Picture 2" descr="E:\Shyamananda\eXPERIMENT\Western Chemi doc\2018\August\shyam actin tubl30s 2018.08.25_07.06.53_Ch\shyam actin tubl30s 2018.08.25_07.06.53_Ch+Marker.jpg"/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760" t="18897" r="48338" b="55796"/>
              <a:stretch/>
            </p:blipFill>
            <p:spPr bwMode="auto">
              <a:xfrm>
                <a:off x="7010400" y="1105234"/>
                <a:ext cx="1447800" cy="244399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35" name="TextBox 34"/>
              <p:cNvSpPr txBox="1"/>
              <p:nvPr/>
            </p:nvSpPr>
            <p:spPr>
              <a:xfrm>
                <a:off x="7214486" y="877589"/>
                <a:ext cx="1301102" cy="2996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0      10   100</a:t>
                </a: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7367829" y="657098"/>
                <a:ext cx="1166711" cy="2996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DLc</a:t>
                </a: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g</a:t>
                </a: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/ml)</a:t>
                </a: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8469957" y="1741488"/>
                <a:ext cx="848885" cy="2996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β-Tubulin</a:t>
                </a:r>
              </a:p>
            </p:txBody>
          </p:sp>
        </p:grpSp>
      </p:grpSp>
      <p:grpSp>
        <p:nvGrpSpPr>
          <p:cNvPr id="42" name="Group 41">
            <a:extLst>
              <a:ext uri="{FF2B5EF4-FFF2-40B4-BE49-F238E27FC236}">
                <a16:creationId xmlns:a16="http://schemas.microsoft.com/office/drawing/2014/main" id="{0E7690F7-3957-6CF1-3F73-CBB48F229E13}"/>
              </a:ext>
            </a:extLst>
          </p:cNvPr>
          <p:cNvGrpSpPr/>
          <p:nvPr/>
        </p:nvGrpSpPr>
        <p:grpSpPr>
          <a:xfrm>
            <a:off x="1622693" y="3749482"/>
            <a:ext cx="7512733" cy="2754467"/>
            <a:chOff x="1365265" y="3738743"/>
            <a:chExt cx="7775855" cy="2979819"/>
          </a:xfrm>
        </p:grpSpPr>
        <p:grpSp>
          <p:nvGrpSpPr>
            <p:cNvPr id="13" name="Group 12"/>
            <p:cNvGrpSpPr/>
            <p:nvPr/>
          </p:nvGrpSpPr>
          <p:grpSpPr>
            <a:xfrm>
              <a:off x="1365265" y="3745129"/>
              <a:ext cx="5408282" cy="2973433"/>
              <a:chOff x="2681987" y="3507790"/>
              <a:chExt cx="5408284" cy="2973433"/>
            </a:xfrm>
          </p:grpSpPr>
          <p:grpSp>
            <p:nvGrpSpPr>
              <p:cNvPr id="5" name="Group 4"/>
              <p:cNvGrpSpPr/>
              <p:nvPr/>
            </p:nvGrpSpPr>
            <p:grpSpPr>
              <a:xfrm>
                <a:off x="6009435" y="3507790"/>
                <a:ext cx="2080836" cy="2973433"/>
                <a:chOff x="6009435" y="3507790"/>
                <a:chExt cx="2080836" cy="2973433"/>
              </a:xfrm>
            </p:grpSpPr>
            <p:pic>
              <p:nvPicPr>
                <p:cNvPr id="9" name="Picture 6" descr="F:\Shyam ERK_tubulin_ACAT2_8_19_08_2018 -\Shyama_tubulinERK20S 2018.08.19_07.07.19_Ch\Shyama_tubulinERK20S 2018.08.19_07.07.19_Ch+Marker.jpg"/>
                <p:cNvPicPr>
                  <a:picLocks noChangeAspect="1" noChangeArrowheads="1"/>
                </p:cNvPicPr>
                <p:nvPr/>
              </p:nvPicPr>
              <p:blipFill rotWithShape="1">
                <a:blip r:embed="rId6" cstate="print">
                  <a:grayscl/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brightnessContrast contrast="-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7944" t="48441" r="29610" b="26189"/>
                <a:stretch/>
              </p:blipFill>
              <p:spPr bwMode="auto">
                <a:xfrm>
                  <a:off x="6009435" y="3945159"/>
                  <a:ext cx="1610565" cy="2536064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16" name="TextBox 15"/>
                <p:cNvSpPr txBox="1"/>
                <p:nvPr/>
              </p:nvSpPr>
              <p:spPr>
                <a:xfrm>
                  <a:off x="7572285" y="4936192"/>
                  <a:ext cx="517986" cy="29966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RK</a:t>
                  </a:r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6214216" y="3728281"/>
                  <a:ext cx="1301103" cy="29966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 0    10     100</a:t>
                  </a:r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>
                  <a:off x="6367560" y="3507790"/>
                  <a:ext cx="1183304" cy="29966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HDLc</a:t>
                  </a:r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</a:t>
                  </a:r>
                  <a:r>
                    <a:rPr lang="en-US" sz="12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g</a:t>
                  </a:r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/ml)</a:t>
                  </a:r>
                </a:p>
              </p:txBody>
            </p:sp>
          </p:grpSp>
          <p:sp>
            <p:nvSpPr>
              <p:cNvPr id="27" name="TextBox 26"/>
              <p:cNvSpPr txBox="1"/>
              <p:nvPr/>
            </p:nvSpPr>
            <p:spPr>
              <a:xfrm>
                <a:off x="3351719" y="4508787"/>
                <a:ext cx="509690" cy="2996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SA</a:t>
                </a: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2681987" y="5470456"/>
                <a:ext cx="1157562" cy="2996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hymotrypsin</a:t>
                </a:r>
              </a:p>
            </p:txBody>
          </p:sp>
        </p:grpSp>
        <p:grpSp>
          <p:nvGrpSpPr>
            <p:cNvPr id="8" name="Group 7"/>
            <p:cNvGrpSpPr/>
            <p:nvPr/>
          </p:nvGrpSpPr>
          <p:grpSpPr>
            <a:xfrm>
              <a:off x="2522792" y="3738743"/>
              <a:ext cx="2143552" cy="2968000"/>
              <a:chOff x="6031092" y="476165"/>
              <a:chExt cx="2143552" cy="2968000"/>
            </a:xfrm>
          </p:grpSpPr>
          <p:pic>
            <p:nvPicPr>
              <p:cNvPr id="1027" name="Picture 3" descr="F:\Shyam pERK_LXR_pJNK_pp38_18_08_2018\Shyam_pERK_5s 2018.08.18_08.47.50_Ch\Shyam_pERK_5s 2018.08.18_08.47.50_Ch+Marker.jpg"/>
              <p:cNvPicPr>
                <a:picLocks noChangeAspect="1" noChangeArrowheads="1"/>
              </p:cNvPicPr>
              <p:nvPr/>
            </p:nvPicPr>
            <p:blipFill rotWithShape="1">
              <a:blip r:embed="rId8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0154" t="35888" r="28240" b="37943"/>
              <a:stretch/>
            </p:blipFill>
            <p:spPr bwMode="auto">
              <a:xfrm>
                <a:off x="6031092" y="914401"/>
                <a:ext cx="1588908" cy="252976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4" name="TextBox 13"/>
              <p:cNvSpPr txBox="1"/>
              <p:nvPr/>
            </p:nvSpPr>
            <p:spPr>
              <a:xfrm>
                <a:off x="7568724" y="1838620"/>
                <a:ext cx="605920" cy="2996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ERK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6239522" y="678900"/>
                <a:ext cx="1256305" cy="2996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  0     10    100</a:t>
                </a: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6410621" y="476165"/>
                <a:ext cx="1183303" cy="2996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DLc</a:t>
                </a: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g</a:t>
                </a: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/ml)</a:t>
                </a:r>
              </a:p>
            </p:txBody>
          </p:sp>
        </p:grpSp>
        <p:pic>
          <p:nvPicPr>
            <p:cNvPr id="33" name="Picture 2" descr="E:\Shyamananda\eXPERIMENT\Western Chemi doc\2018\August\shyam actin tubl30s 2018.08.25_07.06.53_Ch\shyam actin tubl30s 2018.08.25_07.06.53_Ch+Marker.jpg"/>
            <p:cNvPicPr>
              <a:picLocks noChangeAspect="1" noChangeArrowheads="1"/>
            </p:cNvPicPr>
            <p:nvPr/>
          </p:nvPicPr>
          <p:blipFill rotWithShape="1">
            <a:blip r:embed="rId5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360" t="19026" r="25437" b="55140"/>
            <a:stretch/>
          </p:blipFill>
          <p:spPr bwMode="auto">
            <a:xfrm>
              <a:off x="6855932" y="4210361"/>
              <a:ext cx="1462936" cy="249638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8" name="TextBox 37"/>
            <p:cNvSpPr txBox="1"/>
            <p:nvPr/>
          </p:nvSpPr>
          <p:spPr>
            <a:xfrm>
              <a:off x="8292234" y="4886097"/>
              <a:ext cx="848886" cy="29966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β-Tubulin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7060088" y="4022962"/>
              <a:ext cx="1211508" cy="29966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  0    10    100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7213431" y="3802472"/>
              <a:ext cx="1183303" cy="29966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DLc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ug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</a:p>
          </p:txBody>
        </p:sp>
      </p:grpSp>
      <p:sp>
        <p:nvSpPr>
          <p:cNvPr id="43" name="TextBox 42">
            <a:extLst>
              <a:ext uri="{FF2B5EF4-FFF2-40B4-BE49-F238E27FC236}">
                <a16:creationId xmlns:a16="http://schemas.microsoft.com/office/drawing/2014/main" id="{528CC89E-DB51-3B69-CA2A-692C205F7343}"/>
              </a:ext>
            </a:extLst>
          </p:cNvPr>
          <p:cNvSpPr txBox="1"/>
          <p:nvPr/>
        </p:nvSpPr>
        <p:spPr>
          <a:xfrm>
            <a:off x="26036" y="53195"/>
            <a:ext cx="54744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3. F. :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, ERK, and </a:t>
            </a:r>
            <a:r>
              <a:rPr lang="el-GR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 Whole Blot</a:t>
            </a:r>
            <a:endParaRPr lang="en-I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0785AA18-15FD-AC92-0EC6-453041F6D9CB}"/>
              </a:ext>
            </a:extLst>
          </p:cNvPr>
          <p:cNvCxnSpPr/>
          <p:nvPr/>
        </p:nvCxnSpPr>
        <p:spPr>
          <a:xfrm>
            <a:off x="3265714" y="3284376"/>
            <a:ext cx="469329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60596FB3-6815-43FD-FBA8-DB24F2A992EC}"/>
              </a:ext>
            </a:extLst>
          </p:cNvPr>
          <p:cNvSpPr txBox="1"/>
          <p:nvPr/>
        </p:nvSpPr>
        <p:spPr>
          <a:xfrm>
            <a:off x="2146075" y="3172949"/>
            <a:ext cx="10054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ame blot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71EC959-E74A-BE57-5B05-62FEDD1F84F3}"/>
              </a:ext>
            </a:extLst>
          </p:cNvPr>
          <p:cNvSpPr txBox="1"/>
          <p:nvPr/>
        </p:nvSpPr>
        <p:spPr>
          <a:xfrm>
            <a:off x="4863485" y="3259018"/>
            <a:ext cx="16129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-probed for ERK 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E9FCCF7-5624-4D51-BEF1-8F2A1D3BBEB0}"/>
              </a:ext>
            </a:extLst>
          </p:cNvPr>
          <p:cNvSpPr txBox="1"/>
          <p:nvPr/>
        </p:nvSpPr>
        <p:spPr>
          <a:xfrm>
            <a:off x="6698426" y="3267685"/>
            <a:ext cx="19830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-probed for 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Tubulin 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0C0F984C-7F8D-74ED-2712-7CDAE48F64B4}"/>
              </a:ext>
            </a:extLst>
          </p:cNvPr>
          <p:cNvCxnSpPr/>
          <p:nvPr/>
        </p:nvCxnSpPr>
        <p:spPr>
          <a:xfrm>
            <a:off x="3296811" y="6562537"/>
            <a:ext cx="469329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85CC2F50-D22A-3DDE-6C84-51605BB7EA6D}"/>
              </a:ext>
            </a:extLst>
          </p:cNvPr>
          <p:cNvSpPr txBox="1"/>
          <p:nvPr/>
        </p:nvSpPr>
        <p:spPr>
          <a:xfrm>
            <a:off x="2177172" y="6451110"/>
            <a:ext cx="10054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ame blots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51C39D3-9719-FBF0-D7EE-28C22E2EE307}"/>
              </a:ext>
            </a:extLst>
          </p:cNvPr>
          <p:cNvSpPr txBox="1"/>
          <p:nvPr/>
        </p:nvSpPr>
        <p:spPr>
          <a:xfrm>
            <a:off x="4894582" y="6537179"/>
            <a:ext cx="16129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-probed for ERK 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4401034-D9C4-1302-F7CE-1E4E36268BFF}"/>
              </a:ext>
            </a:extLst>
          </p:cNvPr>
          <p:cNvSpPr txBox="1"/>
          <p:nvPr/>
        </p:nvSpPr>
        <p:spPr>
          <a:xfrm>
            <a:off x="6729523" y="6545846"/>
            <a:ext cx="19830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-probed for 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Tubulin </a:t>
            </a:r>
          </a:p>
        </p:txBody>
      </p:sp>
    </p:spTree>
    <p:extLst>
      <p:ext uri="{BB962C8B-B14F-4D97-AF65-F5344CB8AC3E}">
        <p14:creationId xmlns:p14="http://schemas.microsoft.com/office/powerpoint/2010/main" val="30304798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TextBox 31"/>
          <p:cNvSpPr txBox="1"/>
          <p:nvPr/>
        </p:nvSpPr>
        <p:spPr>
          <a:xfrm>
            <a:off x="-23690" y="0"/>
            <a:ext cx="4421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4.F. : LDLR and </a:t>
            </a:r>
            <a:r>
              <a:rPr lang="el-GR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Actin whole Blot</a:t>
            </a:r>
          </a:p>
        </p:txBody>
      </p:sp>
      <p:grpSp>
        <p:nvGrpSpPr>
          <p:cNvPr id="1024" name="Group 1023">
            <a:extLst>
              <a:ext uri="{FF2B5EF4-FFF2-40B4-BE49-F238E27FC236}">
                <a16:creationId xmlns:a16="http://schemas.microsoft.com/office/drawing/2014/main" id="{30B43F27-185A-FD88-9462-973D4E6713A3}"/>
              </a:ext>
            </a:extLst>
          </p:cNvPr>
          <p:cNvGrpSpPr/>
          <p:nvPr/>
        </p:nvGrpSpPr>
        <p:grpSpPr>
          <a:xfrm>
            <a:off x="6619683" y="972088"/>
            <a:ext cx="5483689" cy="3405511"/>
            <a:chOff x="6266850" y="35453"/>
            <a:chExt cx="5483689" cy="3405511"/>
          </a:xfrm>
        </p:grpSpPr>
        <p:grpSp>
          <p:nvGrpSpPr>
            <p:cNvPr id="23" name="Group 22"/>
            <p:cNvGrpSpPr/>
            <p:nvPr/>
          </p:nvGrpSpPr>
          <p:grpSpPr>
            <a:xfrm>
              <a:off x="9239960" y="361639"/>
              <a:ext cx="2510579" cy="3065925"/>
              <a:chOff x="5461474" y="3730738"/>
              <a:chExt cx="1694621" cy="2060462"/>
            </a:xfrm>
          </p:grpSpPr>
          <p:pic>
            <p:nvPicPr>
              <p:cNvPr id="1030" name="Picture 6" descr="C:\Users\Students\Desktop\Picture1.jpg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626" t="6966" r="7423" b="5578"/>
              <a:stretch/>
            </p:blipFill>
            <p:spPr bwMode="auto">
              <a:xfrm>
                <a:off x="5461474" y="3730738"/>
                <a:ext cx="1239140" cy="206046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8" name="TextBox 27"/>
              <p:cNvSpPr txBox="1"/>
              <p:nvPr/>
            </p:nvSpPr>
            <p:spPr>
              <a:xfrm>
                <a:off x="6673300" y="5286730"/>
                <a:ext cx="482795" cy="1861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β-Actin</a:t>
                </a:r>
              </a:p>
            </p:txBody>
          </p:sp>
        </p:grpSp>
        <p:grpSp>
          <p:nvGrpSpPr>
            <p:cNvPr id="31" name="Group 30"/>
            <p:cNvGrpSpPr/>
            <p:nvPr/>
          </p:nvGrpSpPr>
          <p:grpSpPr>
            <a:xfrm>
              <a:off x="6266850" y="246222"/>
              <a:ext cx="2944514" cy="3194742"/>
              <a:chOff x="5388105" y="627625"/>
              <a:chExt cx="2258176" cy="2305834"/>
            </a:xfrm>
          </p:grpSpPr>
          <p:grpSp>
            <p:nvGrpSpPr>
              <p:cNvPr id="13" name="Group 12"/>
              <p:cNvGrpSpPr/>
              <p:nvPr/>
            </p:nvGrpSpPr>
            <p:grpSpPr>
              <a:xfrm>
                <a:off x="5801714" y="627625"/>
                <a:ext cx="1844567" cy="2305834"/>
                <a:chOff x="7028921" y="619975"/>
                <a:chExt cx="1844567" cy="2198696"/>
              </a:xfrm>
            </p:grpSpPr>
            <p:grpSp>
              <p:nvGrpSpPr>
                <p:cNvPr id="14" name="Group 13"/>
                <p:cNvGrpSpPr/>
                <p:nvPr/>
              </p:nvGrpSpPr>
              <p:grpSpPr>
                <a:xfrm>
                  <a:off x="7028921" y="619975"/>
                  <a:ext cx="1447800" cy="2198696"/>
                  <a:chOff x="6858001" y="585791"/>
                  <a:chExt cx="1447800" cy="2198696"/>
                </a:xfrm>
              </p:grpSpPr>
              <p:pic>
                <p:nvPicPr>
                  <p:cNvPr id="16" name="Picture 2" descr="E:\Shyamananda\eXPERIMENT\Western Chemi doc\2018\shyam LDLR_Actin_Srbp1_GAPDH 03032018\shyam LDLR_SRBP1 3 2018.03.04_11.03.18_Ch\shyam LDLR_SRBP1 3 2018.03.04_11.03.18_Ch+Marker.jpg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49710" t="15877" r="26204" b="57423"/>
                  <a:stretch/>
                </p:blipFill>
                <p:spPr bwMode="auto">
                  <a:xfrm>
                    <a:off x="6858001" y="632626"/>
                    <a:ext cx="1447800" cy="2151861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sp>
                <p:nvSpPr>
                  <p:cNvPr id="17" name="TextBox 16"/>
                  <p:cNvSpPr txBox="1"/>
                  <p:nvPr/>
                </p:nvSpPr>
                <p:spPr>
                  <a:xfrm>
                    <a:off x="6978283" y="585791"/>
                    <a:ext cx="1142319" cy="1694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  0    1   10    50   100 </a:t>
                    </a:r>
                  </a:p>
                </p:txBody>
              </p:sp>
            </p:grpSp>
            <p:sp>
              <p:nvSpPr>
                <p:cNvPr id="15" name="TextBox 14"/>
                <p:cNvSpPr txBox="1"/>
                <p:nvPr/>
              </p:nvSpPr>
              <p:spPr>
                <a:xfrm>
                  <a:off x="8417150" y="1099654"/>
                  <a:ext cx="456338" cy="19063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DLR</a:t>
                  </a:r>
                </a:p>
              </p:txBody>
            </p:sp>
          </p:grpSp>
          <p:sp>
            <p:nvSpPr>
              <p:cNvPr id="33" name="TextBox 32"/>
              <p:cNvSpPr txBox="1"/>
              <p:nvPr/>
            </p:nvSpPr>
            <p:spPr>
              <a:xfrm>
                <a:off x="5409806" y="1352375"/>
                <a:ext cx="444044" cy="1999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β-Gal</a:t>
                </a: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5388105" y="1803977"/>
                <a:ext cx="389953" cy="1999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SA</a:t>
                </a:r>
              </a:p>
            </p:txBody>
          </p:sp>
        </p:grpSp>
        <p:sp>
          <p:nvSpPr>
            <p:cNvPr id="29" name="TextBox 28"/>
            <p:cNvSpPr txBox="1"/>
            <p:nvPr/>
          </p:nvSpPr>
          <p:spPr>
            <a:xfrm>
              <a:off x="7200096" y="35453"/>
              <a:ext cx="109998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HDL(ug/ml)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AD436673-484C-82ED-152C-4706D26F579F}"/>
                </a:ext>
              </a:extLst>
            </p:cNvPr>
            <p:cNvSpPr txBox="1"/>
            <p:nvPr/>
          </p:nvSpPr>
          <p:spPr>
            <a:xfrm>
              <a:off x="9421611" y="77049"/>
              <a:ext cx="13644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HDL(ug/ml)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48F9A2BA-1315-EDC0-A9A1-E51DC326F8BA}"/>
                </a:ext>
              </a:extLst>
            </p:cNvPr>
            <p:cNvSpPr txBox="1"/>
            <p:nvPr/>
          </p:nvSpPr>
          <p:spPr>
            <a:xfrm>
              <a:off x="9303677" y="351161"/>
              <a:ext cx="152477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  0     1    10    50   100</a:t>
              </a:r>
            </a:p>
          </p:txBody>
        </p:sp>
      </p:grpSp>
      <p:grpSp>
        <p:nvGrpSpPr>
          <p:cNvPr id="1025" name="Group 1024">
            <a:extLst>
              <a:ext uri="{FF2B5EF4-FFF2-40B4-BE49-F238E27FC236}">
                <a16:creationId xmlns:a16="http://schemas.microsoft.com/office/drawing/2014/main" id="{9FE78022-AA5C-0F4F-717D-8CEAC153F42F}"/>
              </a:ext>
            </a:extLst>
          </p:cNvPr>
          <p:cNvGrpSpPr/>
          <p:nvPr/>
        </p:nvGrpSpPr>
        <p:grpSpPr>
          <a:xfrm>
            <a:off x="987260" y="972089"/>
            <a:ext cx="5595838" cy="3506440"/>
            <a:chOff x="786420" y="75343"/>
            <a:chExt cx="5595838" cy="3506440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35856996-0561-2DB1-B98B-C165927D6031}"/>
                </a:ext>
              </a:extLst>
            </p:cNvPr>
            <p:cNvGrpSpPr/>
            <p:nvPr/>
          </p:nvGrpSpPr>
          <p:grpSpPr>
            <a:xfrm>
              <a:off x="786420" y="75343"/>
              <a:ext cx="5595838" cy="3506440"/>
              <a:chOff x="267036" y="758736"/>
              <a:chExt cx="4193966" cy="2462162"/>
            </a:xfrm>
          </p:grpSpPr>
          <p:grpSp>
            <p:nvGrpSpPr>
              <p:cNvPr id="24" name="Group 23"/>
              <p:cNvGrpSpPr/>
              <p:nvPr/>
            </p:nvGrpSpPr>
            <p:grpSpPr>
              <a:xfrm>
                <a:off x="2459797" y="947590"/>
                <a:ext cx="2001205" cy="2273308"/>
                <a:chOff x="1349275" y="3738291"/>
                <a:chExt cx="2001205" cy="2273308"/>
              </a:xfrm>
            </p:grpSpPr>
            <p:pic>
              <p:nvPicPr>
                <p:cNvPr id="1026" name="Picture 2" descr="E:\Shyamananda\eXPERIMENT\Western Chemi doc\2018\Shyam Gapdh_Tubuli _Actin_B catenin_07032018\Shyama actin_bcaten3 2018.03.07_08.37.20_Ch\Shyama actin_bcaten3 2018.03.07_08.37.20_Ch+Marker.jpg"/>
                <p:cNvPicPr>
                  <a:picLocks noChangeAspect="1" noChangeArrowheads="1"/>
                </p:cNvPicPr>
                <p:nvPr/>
              </p:nvPicPr>
              <p:blipFill rotWithShape="1">
                <a:blip r:embed="rId4" cstate="print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sharpenSoften amount="-8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7212" t="20042" r="49315" b="53624"/>
                <a:stretch/>
              </p:blipFill>
              <p:spPr bwMode="auto">
                <a:xfrm>
                  <a:off x="1349275" y="3738291"/>
                  <a:ext cx="1482690" cy="2273308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22" name="TextBox 21"/>
                <p:cNvSpPr txBox="1"/>
                <p:nvPr/>
              </p:nvSpPr>
              <p:spPr>
                <a:xfrm>
                  <a:off x="2814407" y="5404231"/>
                  <a:ext cx="536073" cy="19450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-Actin</a:t>
                  </a:r>
                </a:p>
              </p:txBody>
            </p:sp>
          </p:grpSp>
          <p:grpSp>
            <p:nvGrpSpPr>
              <p:cNvPr id="30" name="Group 29"/>
              <p:cNvGrpSpPr/>
              <p:nvPr/>
            </p:nvGrpSpPr>
            <p:grpSpPr>
              <a:xfrm>
                <a:off x="267036" y="957201"/>
                <a:ext cx="2160596" cy="2263697"/>
                <a:chOff x="1302198" y="723371"/>
                <a:chExt cx="2160596" cy="2210088"/>
              </a:xfrm>
            </p:grpSpPr>
            <p:grpSp>
              <p:nvGrpSpPr>
                <p:cNvPr id="8" name="Group 7"/>
                <p:cNvGrpSpPr/>
                <p:nvPr/>
              </p:nvGrpSpPr>
              <p:grpSpPr>
                <a:xfrm>
                  <a:off x="1664231" y="723371"/>
                  <a:ext cx="1798563" cy="2210088"/>
                  <a:chOff x="2374086" y="675624"/>
                  <a:chExt cx="1798563" cy="2210088"/>
                </a:xfrm>
              </p:grpSpPr>
              <p:pic>
                <p:nvPicPr>
                  <p:cNvPr id="11" name="Picture 2" descr="E:\Shyamananda\eXPERIMENT\Western Chemi doc\2018\shyam LDLR_Actin_Srbp1_GAPDH 03032018\shyam LDLR_SRBP1 3 2018.03.04_11.03.18_Ch\shyam LDLR_SRBP1 3 2018.03.04_11.03.18_Ch+Marker.jpg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7954" t="15877" r="48754" b="57423"/>
                  <a:stretch/>
                </p:blipFill>
                <p:spPr bwMode="auto">
                  <a:xfrm>
                    <a:off x="2374086" y="675624"/>
                    <a:ext cx="1402284" cy="2210088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sp>
                <p:nvSpPr>
                  <p:cNvPr id="10" name="TextBox 9"/>
                  <p:cNvSpPr txBox="1"/>
                  <p:nvPr/>
                </p:nvSpPr>
                <p:spPr>
                  <a:xfrm>
                    <a:off x="3726682" y="1165407"/>
                    <a:ext cx="445967" cy="18989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DLR</a:t>
                    </a:r>
                  </a:p>
                </p:txBody>
              </p:sp>
            </p:grpSp>
            <p:sp>
              <p:nvSpPr>
                <p:cNvPr id="25" name="TextBox 24"/>
                <p:cNvSpPr txBox="1"/>
                <p:nvPr/>
              </p:nvSpPr>
              <p:spPr>
                <a:xfrm>
                  <a:off x="1302198" y="1336736"/>
                  <a:ext cx="433952" cy="1898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-Gal</a:t>
                  </a:r>
                </a:p>
              </p:txBody>
            </p:sp>
            <p:sp>
              <p:nvSpPr>
                <p:cNvPr id="26" name="TextBox 25"/>
                <p:cNvSpPr txBox="1"/>
                <p:nvPr/>
              </p:nvSpPr>
              <p:spPr>
                <a:xfrm>
                  <a:off x="1357043" y="1831890"/>
                  <a:ext cx="381090" cy="1898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SA</a:t>
                  </a:r>
                </a:p>
              </p:txBody>
            </p:sp>
          </p:grpSp>
          <p:sp>
            <p:nvSpPr>
              <p:cNvPr id="27" name="TextBox 26"/>
              <p:cNvSpPr txBox="1"/>
              <p:nvPr/>
            </p:nvSpPr>
            <p:spPr>
              <a:xfrm>
                <a:off x="2876590" y="758736"/>
                <a:ext cx="833833" cy="216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DL (ug/ml)</a:t>
                </a:r>
              </a:p>
            </p:txBody>
          </p:sp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0769DA35-1165-1141-78D9-CD2EE3123C32}"/>
                  </a:ext>
                </a:extLst>
              </p:cNvPr>
              <p:cNvSpPr txBox="1"/>
              <p:nvPr/>
            </p:nvSpPr>
            <p:spPr>
              <a:xfrm>
                <a:off x="2710725" y="897930"/>
                <a:ext cx="1301376" cy="1728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0     1       10    50   100    </a:t>
                </a:r>
              </a:p>
            </p:txBody>
          </p:sp>
        </p:grp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86BBC928-43DA-6370-5B58-00EB32005F00}"/>
                </a:ext>
              </a:extLst>
            </p:cNvPr>
            <p:cNvSpPr txBox="1"/>
            <p:nvPr/>
          </p:nvSpPr>
          <p:spPr>
            <a:xfrm>
              <a:off x="1486038" y="297627"/>
              <a:ext cx="173637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  0     1       10    50   100    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25746EA8-69D3-4A2E-65A4-B67FC94C5999}"/>
                </a:ext>
              </a:extLst>
            </p:cNvPr>
            <p:cNvSpPr txBox="1"/>
            <p:nvPr/>
          </p:nvSpPr>
          <p:spPr>
            <a:xfrm>
              <a:off x="1689135" y="85328"/>
              <a:ext cx="111254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LDL (ug/ml)</a:t>
              </a:r>
            </a:p>
          </p:txBody>
        </p:sp>
      </p:grpSp>
      <p:cxnSp>
        <p:nvCxnSpPr>
          <p:cNvPr id="2" name="Straight Connector 1">
            <a:extLst>
              <a:ext uri="{FF2B5EF4-FFF2-40B4-BE49-F238E27FC236}">
                <a16:creationId xmlns:a16="http://schemas.microsoft.com/office/drawing/2014/main" id="{C0F70B87-2790-4CAE-8DFC-9B89D29DAC5C}"/>
              </a:ext>
            </a:extLst>
          </p:cNvPr>
          <p:cNvCxnSpPr>
            <a:cxnSpLocks/>
          </p:cNvCxnSpPr>
          <p:nvPr/>
        </p:nvCxnSpPr>
        <p:spPr>
          <a:xfrm>
            <a:off x="1819469" y="4611839"/>
            <a:ext cx="3564294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5C2C85C1-61B0-3D4F-1D07-0DA65FE34082}"/>
              </a:ext>
            </a:extLst>
          </p:cNvPr>
          <p:cNvSpPr txBox="1"/>
          <p:nvPr/>
        </p:nvSpPr>
        <p:spPr>
          <a:xfrm>
            <a:off x="699830" y="4500412"/>
            <a:ext cx="10054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ame blot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45290C3-03E8-1BB6-2755-A029A6F0C0CD}"/>
              </a:ext>
            </a:extLst>
          </p:cNvPr>
          <p:cNvSpPr txBox="1"/>
          <p:nvPr/>
        </p:nvSpPr>
        <p:spPr>
          <a:xfrm>
            <a:off x="4216928" y="4638911"/>
            <a:ext cx="17764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-probed for 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FCDD08E1-C036-2FD2-6FF9-1E211D365778}"/>
              </a:ext>
            </a:extLst>
          </p:cNvPr>
          <p:cNvCxnSpPr>
            <a:cxnSpLocks/>
          </p:cNvCxnSpPr>
          <p:nvPr/>
        </p:nvCxnSpPr>
        <p:spPr>
          <a:xfrm>
            <a:off x="7477860" y="4611839"/>
            <a:ext cx="3564294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2A7F85C8-61E0-1B0B-3AFD-A9CA48B9A566}"/>
              </a:ext>
            </a:extLst>
          </p:cNvPr>
          <p:cNvSpPr txBox="1"/>
          <p:nvPr/>
        </p:nvSpPr>
        <p:spPr>
          <a:xfrm>
            <a:off x="6358221" y="4500412"/>
            <a:ext cx="10054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ame blot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FF0BBBA-02B4-EF99-9B37-DBB7F6BFD0DA}"/>
              </a:ext>
            </a:extLst>
          </p:cNvPr>
          <p:cNvSpPr txBox="1"/>
          <p:nvPr/>
        </p:nvSpPr>
        <p:spPr>
          <a:xfrm>
            <a:off x="9875319" y="4638911"/>
            <a:ext cx="18197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-probed for 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Actin </a:t>
            </a:r>
          </a:p>
        </p:txBody>
      </p:sp>
    </p:spTree>
    <p:extLst>
      <p:ext uri="{BB962C8B-B14F-4D97-AF65-F5344CB8AC3E}">
        <p14:creationId xmlns:p14="http://schemas.microsoft.com/office/powerpoint/2010/main" val="352836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2F3F839F-9BDE-01F2-665D-20F9B2131BD9}"/>
              </a:ext>
            </a:extLst>
          </p:cNvPr>
          <p:cNvGrpSpPr/>
          <p:nvPr/>
        </p:nvGrpSpPr>
        <p:grpSpPr>
          <a:xfrm>
            <a:off x="1816100" y="1422401"/>
            <a:ext cx="3654031" cy="3416300"/>
            <a:chOff x="400280" y="3642128"/>
            <a:chExt cx="3441654" cy="3093905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A9CAB641-12FC-6B60-9293-832D8324AB92}"/>
                </a:ext>
              </a:extLst>
            </p:cNvPr>
            <p:cNvGrpSpPr/>
            <p:nvPr/>
          </p:nvGrpSpPr>
          <p:grpSpPr>
            <a:xfrm>
              <a:off x="400280" y="3726883"/>
              <a:ext cx="3441654" cy="3009150"/>
              <a:chOff x="1339691" y="833926"/>
              <a:chExt cx="2770412" cy="2326993"/>
            </a:xfrm>
          </p:grpSpPr>
          <p:pic>
            <p:nvPicPr>
              <p:cNvPr id="5" name="Picture 5" descr="E:\Shyamananda\eXPERIMENT\Western Chemi doc\2018\May\Shyam pERK_FASN_Tubulin cav 1\Fasn Tubulin.jpg">
                <a:extLst>
                  <a:ext uri="{FF2B5EF4-FFF2-40B4-BE49-F238E27FC236}">
                    <a16:creationId xmlns:a16="http://schemas.microsoft.com/office/drawing/2014/main" id="{4CAB9DB7-6DCC-5DBC-3DA5-D63C8EFB66D5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054" t="18226" r="71094" b="45394"/>
              <a:stretch/>
            </p:blipFill>
            <p:spPr bwMode="auto">
              <a:xfrm>
                <a:off x="2020724" y="833926"/>
                <a:ext cx="1484476" cy="2326993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dk1"/>
              </a:lnRef>
              <a:fillRef idx="100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</p:pic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6D925527-63FA-8F56-9402-B3D69752648E}"/>
                  </a:ext>
                </a:extLst>
              </p:cNvPr>
              <p:cNvSpPr txBox="1"/>
              <p:nvPr/>
            </p:nvSpPr>
            <p:spPr>
              <a:xfrm>
                <a:off x="3419432" y="1270657"/>
                <a:ext cx="513461" cy="2142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ASN 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D98DF43D-CA68-67CC-E660-4ED846553745}"/>
                  </a:ext>
                </a:extLst>
              </p:cNvPr>
              <p:cNvSpPr txBox="1"/>
              <p:nvPr/>
            </p:nvSpPr>
            <p:spPr>
              <a:xfrm>
                <a:off x="1696757" y="2174888"/>
                <a:ext cx="385514" cy="1939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SA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D174AFF4-B5E5-31FC-F395-666E53C5E95F}"/>
                  </a:ext>
                </a:extLst>
              </p:cNvPr>
              <p:cNvSpPr txBox="1"/>
              <p:nvPr/>
            </p:nvSpPr>
            <p:spPr>
              <a:xfrm>
                <a:off x="1339691" y="2647259"/>
                <a:ext cx="744046" cy="1939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valbumin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D91F29D0-E9CE-4078-4433-ED7FB791DA77}"/>
                  </a:ext>
                </a:extLst>
              </p:cNvPr>
              <p:cNvSpPr txBox="1"/>
              <p:nvPr/>
            </p:nvSpPr>
            <p:spPr>
              <a:xfrm>
                <a:off x="1654041" y="1524000"/>
                <a:ext cx="431698" cy="1939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Symbol" panose="05050102010706020507" pitchFamily="18" charset="2"/>
                    <a:cs typeface="Arial" panose="020B0604020202020204" pitchFamily="34" charset="0"/>
                  </a:rPr>
                  <a:t>b</a:t>
                </a: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Gal</a:t>
                </a:r>
                <a:endParaRPr lang="en-US" sz="1200" b="1" dirty="0"/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49821085-8242-0DAE-277D-238FFF5EBABF}"/>
                  </a:ext>
                </a:extLst>
              </p:cNvPr>
              <p:cNvSpPr txBox="1"/>
              <p:nvPr/>
            </p:nvSpPr>
            <p:spPr>
              <a:xfrm>
                <a:off x="3451278" y="2390735"/>
                <a:ext cx="658825" cy="1939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Symbol" panose="05050102010706020507" pitchFamily="18" charset="2"/>
                    <a:cs typeface="Arial" panose="020B0604020202020204" pitchFamily="34" charset="0"/>
                  </a:rPr>
                  <a:t>b</a:t>
                </a: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Tubulin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A27B9422-DAF4-F850-1DEB-3F0127E43857}"/>
                  </a:ext>
                </a:extLst>
              </p:cNvPr>
              <p:cNvSpPr txBox="1"/>
              <p:nvPr/>
            </p:nvSpPr>
            <p:spPr>
              <a:xfrm>
                <a:off x="2330265" y="939287"/>
                <a:ext cx="1113840" cy="1904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    1     10    50   100</a:t>
                </a:r>
              </a:p>
            </p:txBody>
          </p:sp>
        </p:grp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A8E1D842-119C-3B70-9719-24C377FBA59C}"/>
                </a:ext>
              </a:extLst>
            </p:cNvPr>
            <p:cNvSpPr txBox="1"/>
            <p:nvPr/>
          </p:nvSpPr>
          <p:spPr>
            <a:xfrm>
              <a:off x="1771194" y="3642128"/>
              <a:ext cx="1047886" cy="2787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LDL (ug/ml)</a:t>
              </a: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3813DE57-AF45-9DE0-7578-067605B1AB5D}"/>
              </a:ext>
            </a:extLst>
          </p:cNvPr>
          <p:cNvGrpSpPr/>
          <p:nvPr/>
        </p:nvGrpSpPr>
        <p:grpSpPr>
          <a:xfrm>
            <a:off x="6950236" y="1515988"/>
            <a:ext cx="3768481" cy="3322713"/>
            <a:chOff x="6327442" y="3861512"/>
            <a:chExt cx="3325584" cy="2940499"/>
          </a:xfrm>
        </p:grpSpPr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97BFCA57-2E36-15D4-C33B-8DA2F10173D0}"/>
                </a:ext>
              </a:extLst>
            </p:cNvPr>
            <p:cNvGrpSpPr/>
            <p:nvPr/>
          </p:nvGrpSpPr>
          <p:grpSpPr>
            <a:xfrm>
              <a:off x="6327442" y="4087984"/>
              <a:ext cx="3325584" cy="2714027"/>
              <a:chOff x="5735627" y="880112"/>
              <a:chExt cx="2912676" cy="2295363"/>
            </a:xfrm>
          </p:grpSpPr>
          <p:pic>
            <p:nvPicPr>
              <p:cNvPr id="15" name="Picture 5" descr="E:\Shyamananda\eXPERIMENT\Western Chemi doc\2018\May\Shyam pERK_FASN_Tubulin cav 1\Fasn Tubulin.jpg">
                <a:extLst>
                  <a:ext uri="{FF2B5EF4-FFF2-40B4-BE49-F238E27FC236}">
                    <a16:creationId xmlns:a16="http://schemas.microsoft.com/office/drawing/2014/main" id="{B0F07FFA-9F37-D955-E7D0-458AA6AC80C5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906" t="21054" r="55533" b="44210"/>
              <a:stretch/>
            </p:blipFill>
            <p:spPr bwMode="auto">
              <a:xfrm>
                <a:off x="6553200" y="953568"/>
                <a:ext cx="1447800" cy="222190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CB62F882-BDEA-FABF-6227-FB40AC168DFA}"/>
                  </a:ext>
                </a:extLst>
              </p:cNvPr>
              <p:cNvSpPr txBox="1"/>
              <p:nvPr/>
            </p:nvSpPr>
            <p:spPr>
              <a:xfrm>
                <a:off x="7847397" y="1156888"/>
                <a:ext cx="493010" cy="2073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ASN 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C1756048-2C64-2BC8-5D4D-CDF8A2CEFA37}"/>
                  </a:ext>
                </a:extLst>
              </p:cNvPr>
              <p:cNvSpPr txBox="1"/>
              <p:nvPr/>
            </p:nvSpPr>
            <p:spPr>
              <a:xfrm>
                <a:off x="6123010" y="2105799"/>
                <a:ext cx="393001" cy="2073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SA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C7338E73-2775-4F61-1D03-04B047D0305C}"/>
                  </a:ext>
                </a:extLst>
              </p:cNvPr>
              <p:cNvSpPr txBox="1"/>
              <p:nvPr/>
            </p:nvSpPr>
            <p:spPr>
              <a:xfrm>
                <a:off x="5735627" y="2609657"/>
                <a:ext cx="758497" cy="2073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valbumin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8FC8401F-C95E-86D3-8786-1FC591AE9006}"/>
                  </a:ext>
                </a:extLst>
              </p:cNvPr>
              <p:cNvSpPr txBox="1"/>
              <p:nvPr/>
            </p:nvSpPr>
            <p:spPr>
              <a:xfrm>
                <a:off x="6048364" y="1483499"/>
                <a:ext cx="447516" cy="2073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β-Gal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EC8885D8-CD55-FC6F-83C5-8139DC5FD2C7}"/>
                  </a:ext>
                </a:extLst>
              </p:cNvPr>
              <p:cNvSpPr txBox="1"/>
              <p:nvPr/>
            </p:nvSpPr>
            <p:spPr>
              <a:xfrm>
                <a:off x="7969249" y="2286247"/>
                <a:ext cx="679054" cy="2073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β-Tubulin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F7B92087-54D0-B210-7E39-63B1265A7614}"/>
                  </a:ext>
                </a:extLst>
              </p:cNvPr>
              <p:cNvSpPr txBox="1"/>
              <p:nvPr/>
            </p:nvSpPr>
            <p:spPr>
              <a:xfrm>
                <a:off x="6641399" y="880112"/>
                <a:ext cx="1123991" cy="1842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      1     10    50   100</a:t>
                </a:r>
              </a:p>
            </p:txBody>
          </p:sp>
        </p:grp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D4100482-5E57-550B-74FB-128AF29E41FC}"/>
                </a:ext>
              </a:extLst>
            </p:cNvPr>
            <p:cNvSpPr txBox="1"/>
            <p:nvPr/>
          </p:nvSpPr>
          <p:spPr>
            <a:xfrm>
              <a:off x="7484478" y="3861512"/>
              <a:ext cx="1008671" cy="2723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HDL (ug/ml)</a:t>
              </a:r>
            </a:p>
          </p:txBody>
        </p: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0D00A1BB-4E66-DC9B-5403-F521B7395F8D}"/>
              </a:ext>
            </a:extLst>
          </p:cNvPr>
          <p:cNvSpPr txBox="1"/>
          <p:nvPr/>
        </p:nvSpPr>
        <p:spPr>
          <a:xfrm>
            <a:off x="8319" y="228600"/>
            <a:ext cx="4438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4.F. : FASN &amp; </a:t>
            </a:r>
            <a:r>
              <a:rPr lang="el-GR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 whole Blot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6D207531-A36B-FA0E-7875-5E62E16F2C6F}"/>
              </a:ext>
            </a:extLst>
          </p:cNvPr>
          <p:cNvCxnSpPr>
            <a:cxnSpLocks/>
          </p:cNvCxnSpPr>
          <p:nvPr/>
        </p:nvCxnSpPr>
        <p:spPr>
          <a:xfrm>
            <a:off x="1744824" y="1895007"/>
            <a:ext cx="0" cy="2786381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307B51A4-E599-392A-A7D7-8AAD86266E4B}"/>
              </a:ext>
            </a:extLst>
          </p:cNvPr>
          <p:cNvSpPr txBox="1"/>
          <p:nvPr/>
        </p:nvSpPr>
        <p:spPr>
          <a:xfrm>
            <a:off x="739421" y="2857840"/>
            <a:ext cx="10054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ame blots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BB3AA3A-95AD-C5E9-EA5B-FEF0A005A401}"/>
              </a:ext>
            </a:extLst>
          </p:cNvPr>
          <p:cNvSpPr txBox="1"/>
          <p:nvPr/>
        </p:nvSpPr>
        <p:spPr>
          <a:xfrm>
            <a:off x="671878" y="3789832"/>
            <a:ext cx="111843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-probed for </a:t>
            </a:r>
            <a:r>
              <a:rPr lang="en-US" sz="1200" b="1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Tubulin 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8EFD7314-D113-4C47-A013-98DFA040D53C}"/>
              </a:ext>
            </a:extLst>
          </p:cNvPr>
          <p:cNvCxnSpPr>
            <a:cxnSpLocks/>
          </p:cNvCxnSpPr>
          <p:nvPr/>
        </p:nvCxnSpPr>
        <p:spPr>
          <a:xfrm>
            <a:off x="6858127" y="1895007"/>
            <a:ext cx="0" cy="2786381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84175D42-3A70-B318-BC40-ECF28ACDD178}"/>
              </a:ext>
            </a:extLst>
          </p:cNvPr>
          <p:cNvSpPr txBox="1"/>
          <p:nvPr/>
        </p:nvSpPr>
        <p:spPr>
          <a:xfrm>
            <a:off x="5852724" y="2857840"/>
            <a:ext cx="10054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ame blots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B160E3D-C8D2-19B7-3864-163A9BFB6FF9}"/>
              </a:ext>
            </a:extLst>
          </p:cNvPr>
          <p:cNvSpPr txBox="1"/>
          <p:nvPr/>
        </p:nvSpPr>
        <p:spPr>
          <a:xfrm>
            <a:off x="5777543" y="3767318"/>
            <a:ext cx="111843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-probed for </a:t>
            </a:r>
            <a:r>
              <a:rPr lang="en-US" sz="1200" b="1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Tubulin </a:t>
            </a:r>
          </a:p>
        </p:txBody>
      </p:sp>
    </p:spTree>
    <p:extLst>
      <p:ext uri="{BB962C8B-B14F-4D97-AF65-F5344CB8AC3E}">
        <p14:creationId xmlns:p14="http://schemas.microsoft.com/office/powerpoint/2010/main" val="9598862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-314579" y="1525026"/>
            <a:ext cx="4853214" cy="3026320"/>
            <a:chOff x="2056999" y="1157305"/>
            <a:chExt cx="4233535" cy="2723989"/>
          </a:xfrm>
        </p:grpSpPr>
        <p:grpSp>
          <p:nvGrpSpPr>
            <p:cNvPr id="2" name="Group 1"/>
            <p:cNvGrpSpPr/>
            <p:nvPr/>
          </p:nvGrpSpPr>
          <p:grpSpPr>
            <a:xfrm>
              <a:off x="2056999" y="1157305"/>
              <a:ext cx="4233535" cy="2723989"/>
              <a:chOff x="5074124" y="354211"/>
              <a:chExt cx="4233535" cy="2723989"/>
            </a:xfrm>
          </p:grpSpPr>
          <p:grpSp>
            <p:nvGrpSpPr>
              <p:cNvPr id="3" name="Group 2"/>
              <p:cNvGrpSpPr/>
              <p:nvPr/>
            </p:nvGrpSpPr>
            <p:grpSpPr>
              <a:xfrm>
                <a:off x="5074124" y="780093"/>
                <a:ext cx="4233535" cy="2298107"/>
                <a:chOff x="4182204" y="3917236"/>
                <a:chExt cx="4233535" cy="2298107"/>
              </a:xfrm>
            </p:grpSpPr>
            <p:pic>
              <p:nvPicPr>
                <p:cNvPr id="6" name="Picture 2" descr="F:\Shyam ERK_tubulin_ACAT2_8_19_08_2018 -\Shyama_ACAT2_PCNA45S 2018.08.19_07.18.58_Ch\Shyama_ACAT2_PCNA45S 2018.08.19_07.18.58_Ch+Marker.jpg"/>
                <p:cNvPicPr>
                  <a:picLocks noChangeAspect="1" noChangeArrowheads="1"/>
                </p:cNvPicPr>
                <p:nvPr/>
              </p:nvPicPr>
              <p:blipFill rotWithShape="1">
                <a:blip r:embed="rId2" cstate="print">
                  <a:grayscl/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contrast="-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1920" t="20935" r="27148" b="53271"/>
                <a:stretch/>
              </p:blipFill>
              <p:spPr bwMode="auto">
                <a:xfrm>
                  <a:off x="5181600" y="3917236"/>
                  <a:ext cx="2652196" cy="2298107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7" name="TextBox 6"/>
                <p:cNvSpPr txBox="1"/>
                <p:nvPr/>
              </p:nvSpPr>
              <p:spPr>
                <a:xfrm>
                  <a:off x="7781179" y="5089580"/>
                  <a:ext cx="634560" cy="24932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CAT-2</a:t>
                  </a:r>
                </a:p>
              </p:txBody>
            </p:sp>
            <p:sp>
              <p:nvSpPr>
                <p:cNvPr id="8" name="TextBox 7"/>
                <p:cNvSpPr txBox="1"/>
                <p:nvPr/>
              </p:nvSpPr>
              <p:spPr>
                <a:xfrm>
                  <a:off x="4857516" y="4606277"/>
                  <a:ext cx="429566" cy="24932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SA</a:t>
                  </a:r>
                </a:p>
              </p:txBody>
            </p:sp>
            <p:sp>
              <p:nvSpPr>
                <p:cNvPr id="9" name="TextBox 8"/>
                <p:cNvSpPr txBox="1"/>
                <p:nvPr/>
              </p:nvSpPr>
              <p:spPr>
                <a:xfrm>
                  <a:off x="4182204" y="4996372"/>
                  <a:ext cx="1365514" cy="24932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valbumin</a:t>
                  </a:r>
                </a:p>
              </p:txBody>
            </p:sp>
          </p:grpSp>
          <p:sp>
            <p:nvSpPr>
              <p:cNvPr id="4" name="TextBox 3"/>
              <p:cNvSpPr txBox="1"/>
              <p:nvPr/>
            </p:nvSpPr>
            <p:spPr>
              <a:xfrm>
                <a:off x="6271689" y="561200"/>
                <a:ext cx="1172077" cy="2493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 0       10      100</a:t>
                </a:r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6371567" y="354211"/>
                <a:ext cx="983302" cy="2493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DLc</a:t>
                </a: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g</a:t>
                </a: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/ml)</a:t>
                </a:r>
              </a:p>
            </p:txBody>
          </p:sp>
        </p:grpSp>
        <p:sp>
          <p:nvSpPr>
            <p:cNvPr id="10" name="TextBox 9"/>
            <p:cNvSpPr txBox="1"/>
            <p:nvPr/>
          </p:nvSpPr>
          <p:spPr>
            <a:xfrm>
              <a:off x="4601573" y="1362417"/>
              <a:ext cx="1209830" cy="2493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 0       10       100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695764" y="1175617"/>
              <a:ext cx="997285" cy="2493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DLc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ug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</a:p>
          </p:txBody>
        </p:sp>
      </p:grpSp>
      <p:grpSp>
        <p:nvGrpSpPr>
          <p:cNvPr id="16" name="Group 15"/>
          <p:cNvGrpSpPr/>
          <p:nvPr/>
        </p:nvGrpSpPr>
        <p:grpSpPr>
          <a:xfrm>
            <a:off x="8577886" y="1538458"/>
            <a:ext cx="3791914" cy="3099784"/>
            <a:chOff x="5867400" y="2943393"/>
            <a:chExt cx="3027349" cy="2453305"/>
          </a:xfrm>
        </p:grpSpPr>
        <p:pic>
          <p:nvPicPr>
            <p:cNvPr id="17" name="Picture 2" descr="E:\Shyamananda\eXPERIMENT\Western Chemi doc\2018\August\shyam actin tubl30s 2018.08.25_07.06.53_Ch\shyam actin tubl30s 2018.08.25_07.06.53_Ch+Marker.jpg"/>
            <p:cNvPicPr>
              <a:picLocks noChangeAspect="1" noChangeArrowheads="1"/>
            </p:cNvPicPr>
            <p:nvPr/>
          </p:nvPicPr>
          <p:blipFill rotWithShape="1">
            <a:blip r:embed="rId4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379" t="45381" r="29616" b="27952"/>
            <a:stretch/>
          </p:blipFill>
          <p:spPr bwMode="auto">
            <a:xfrm>
              <a:off x="5867400" y="3307962"/>
              <a:ext cx="2392919" cy="208873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8" name="TextBox 17"/>
            <p:cNvSpPr txBox="1"/>
            <p:nvPr/>
          </p:nvSpPr>
          <p:spPr>
            <a:xfrm>
              <a:off x="6086938" y="3120249"/>
              <a:ext cx="969056" cy="2192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   0     10   100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6149565" y="2957437"/>
              <a:ext cx="899948" cy="2192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LDLc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ug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7235982" y="3109404"/>
              <a:ext cx="1072720" cy="2192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    0      10    100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7330757" y="2943393"/>
              <a:ext cx="912746" cy="2192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DLc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ug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8218186" y="4235295"/>
              <a:ext cx="676563" cy="2192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</a:p>
          </p:txBody>
        </p:sp>
      </p:grpSp>
      <p:grpSp>
        <p:nvGrpSpPr>
          <p:cNvPr id="27" name="Group 26">
            <a:extLst>
              <a:ext uri="{FF2B5EF4-FFF2-40B4-BE49-F238E27FC236}">
                <a16:creationId xmlns:a16="http://schemas.microsoft.com/office/drawing/2014/main" id="{1F880099-549F-F94D-0067-E30AE6B3A3D0}"/>
              </a:ext>
            </a:extLst>
          </p:cNvPr>
          <p:cNvGrpSpPr/>
          <p:nvPr/>
        </p:nvGrpSpPr>
        <p:grpSpPr>
          <a:xfrm>
            <a:off x="4664209" y="1472048"/>
            <a:ext cx="3773448" cy="3164975"/>
            <a:chOff x="1900783" y="3605647"/>
            <a:chExt cx="3406940" cy="2742532"/>
          </a:xfrm>
        </p:grpSpPr>
        <p:grpSp>
          <p:nvGrpSpPr>
            <p:cNvPr id="13" name="Group 12"/>
            <p:cNvGrpSpPr/>
            <p:nvPr/>
          </p:nvGrpSpPr>
          <p:grpSpPr>
            <a:xfrm>
              <a:off x="1900783" y="4043129"/>
              <a:ext cx="3406940" cy="2305050"/>
              <a:chOff x="2958458" y="3124200"/>
              <a:chExt cx="3406940" cy="2305050"/>
            </a:xfrm>
          </p:grpSpPr>
          <p:pic>
            <p:nvPicPr>
              <p:cNvPr id="1026" name="Picture 2" descr="E:\Shyamananda\eXPERIMENT\Western Chemi doc\2018\August\Shyama_ACAT1_PTEN_22082018\shyam_ACAT1_10s 2018.08.22_08.39.19_Ch\shyam_ACAT1_10s 2018.08.22_08.39.19_Ch+Marker.jpg"/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069" t="32585" r="28411" b="39689"/>
              <a:stretch/>
            </p:blipFill>
            <p:spPr bwMode="auto">
              <a:xfrm>
                <a:off x="2958458" y="3124200"/>
                <a:ext cx="2758886" cy="230505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4" name="TextBox 13"/>
              <p:cNvSpPr txBox="1"/>
              <p:nvPr/>
            </p:nvSpPr>
            <p:spPr>
              <a:xfrm>
                <a:off x="5688835" y="4284782"/>
                <a:ext cx="676563" cy="2400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CAT-1</a:t>
                </a:r>
              </a:p>
            </p:txBody>
          </p:sp>
        </p:grp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26D043CB-323B-2290-655F-FB3804DC314A}"/>
                </a:ext>
              </a:extLst>
            </p:cNvPr>
            <p:cNvSpPr txBox="1"/>
            <p:nvPr/>
          </p:nvSpPr>
          <p:spPr>
            <a:xfrm>
              <a:off x="2273091" y="3831449"/>
              <a:ext cx="1174055" cy="2400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 0       10     100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1B477FEB-5250-01CD-7113-86A64E19F2E8}"/>
                </a:ext>
              </a:extLst>
            </p:cNvPr>
            <p:cNvSpPr txBox="1"/>
            <p:nvPr/>
          </p:nvSpPr>
          <p:spPr>
            <a:xfrm>
              <a:off x="2317556" y="3605647"/>
              <a:ext cx="1017746" cy="2400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LDLc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ug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968F9F36-B999-F2E8-B830-2D5A46F65B27}"/>
                </a:ext>
              </a:extLst>
            </p:cNvPr>
            <p:cNvSpPr txBox="1"/>
            <p:nvPr/>
          </p:nvSpPr>
          <p:spPr>
            <a:xfrm>
              <a:off x="3624992" y="3831448"/>
              <a:ext cx="1134978" cy="2400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 0      10     100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C54CD945-5C70-D6A5-A1FD-194E823F0D48}"/>
                </a:ext>
              </a:extLst>
            </p:cNvPr>
            <p:cNvSpPr txBox="1"/>
            <p:nvPr/>
          </p:nvSpPr>
          <p:spPr>
            <a:xfrm>
              <a:off x="3698160" y="3617971"/>
              <a:ext cx="1032219" cy="2400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DLc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ug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</a:p>
          </p:txBody>
        </p:sp>
      </p:grpSp>
      <p:sp>
        <p:nvSpPr>
          <p:cNvPr id="28" name="TextBox 27">
            <a:extLst>
              <a:ext uri="{FF2B5EF4-FFF2-40B4-BE49-F238E27FC236}">
                <a16:creationId xmlns:a16="http://schemas.microsoft.com/office/drawing/2014/main" id="{7F7FDF15-62AD-3A96-9057-E7DF359111D5}"/>
              </a:ext>
            </a:extLst>
          </p:cNvPr>
          <p:cNvSpPr txBox="1"/>
          <p:nvPr/>
        </p:nvSpPr>
        <p:spPr>
          <a:xfrm>
            <a:off x="47327" y="583367"/>
            <a:ext cx="55801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4.F. : ACAT-2, ACAT-1, and </a:t>
            </a:r>
            <a:r>
              <a:rPr lang="el-GR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Actin whole Blot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AFE8669A-68F7-017D-092E-17E9630D9918}"/>
              </a:ext>
            </a:extLst>
          </p:cNvPr>
          <p:cNvCxnSpPr>
            <a:cxnSpLocks/>
          </p:cNvCxnSpPr>
          <p:nvPr/>
        </p:nvCxnSpPr>
        <p:spPr>
          <a:xfrm>
            <a:off x="1476011" y="4908451"/>
            <a:ext cx="951545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C62F0344-0C55-DC8E-0FB0-EB9421C172BF}"/>
              </a:ext>
            </a:extLst>
          </p:cNvPr>
          <p:cNvSpPr txBox="1"/>
          <p:nvPr/>
        </p:nvSpPr>
        <p:spPr>
          <a:xfrm>
            <a:off x="356372" y="4797024"/>
            <a:ext cx="10054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ame blots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74AA9C1-15E5-70C0-7791-77E0D7F4F90A}"/>
              </a:ext>
            </a:extLst>
          </p:cNvPr>
          <p:cNvSpPr txBox="1"/>
          <p:nvPr/>
        </p:nvSpPr>
        <p:spPr>
          <a:xfrm>
            <a:off x="5569461" y="4908451"/>
            <a:ext cx="18262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-probed for ACAT-1 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7764C4F-7EF0-6DBC-D473-D93A36575CFF}"/>
              </a:ext>
            </a:extLst>
          </p:cNvPr>
          <p:cNvSpPr txBox="1"/>
          <p:nvPr/>
        </p:nvSpPr>
        <p:spPr>
          <a:xfrm>
            <a:off x="9319823" y="4908451"/>
            <a:ext cx="17764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-probed for 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DEEA928-649E-A354-9B11-5FBD1111F170}"/>
              </a:ext>
            </a:extLst>
          </p:cNvPr>
          <p:cNvSpPr txBox="1"/>
          <p:nvPr/>
        </p:nvSpPr>
        <p:spPr>
          <a:xfrm>
            <a:off x="821488" y="5666653"/>
            <a:ext cx="1065555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Note: The upper section of the 2</a:t>
            </a:r>
            <a:r>
              <a:rPr lang="en-US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and 3</a:t>
            </a:r>
            <a:r>
              <a:rPr lang="en-US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rd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blot image was cut to re-probe for some other molecule which was not used here. </a:t>
            </a:r>
          </a:p>
        </p:txBody>
      </p:sp>
    </p:spTree>
    <p:extLst>
      <p:ext uri="{BB962C8B-B14F-4D97-AF65-F5344CB8AC3E}">
        <p14:creationId xmlns:p14="http://schemas.microsoft.com/office/powerpoint/2010/main" val="33522322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" name="Group 44">
            <a:extLst>
              <a:ext uri="{FF2B5EF4-FFF2-40B4-BE49-F238E27FC236}">
                <a16:creationId xmlns:a16="http://schemas.microsoft.com/office/drawing/2014/main" id="{390D7057-A7DD-1939-ED90-3356439552A4}"/>
              </a:ext>
            </a:extLst>
          </p:cNvPr>
          <p:cNvGrpSpPr/>
          <p:nvPr/>
        </p:nvGrpSpPr>
        <p:grpSpPr>
          <a:xfrm>
            <a:off x="2208180" y="3268414"/>
            <a:ext cx="8713161" cy="2976749"/>
            <a:chOff x="126526" y="3315969"/>
            <a:chExt cx="9203082" cy="3503930"/>
          </a:xfrm>
        </p:grpSpPr>
        <p:sp>
          <p:nvSpPr>
            <p:cNvPr id="7" name="TextBox 6"/>
            <p:cNvSpPr txBox="1"/>
            <p:nvPr/>
          </p:nvSpPr>
          <p:spPr>
            <a:xfrm>
              <a:off x="1133745" y="3369534"/>
              <a:ext cx="1580105" cy="3622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HDL (ug/ml)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8435307" y="5323788"/>
              <a:ext cx="894301" cy="326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grpSp>
          <p:nvGrpSpPr>
            <p:cNvPr id="32" name="Group 31"/>
            <p:cNvGrpSpPr/>
            <p:nvPr/>
          </p:nvGrpSpPr>
          <p:grpSpPr>
            <a:xfrm>
              <a:off x="3737472" y="3937217"/>
              <a:ext cx="2726284" cy="2882682"/>
              <a:chOff x="7054523" y="3527629"/>
              <a:chExt cx="1764458" cy="2282375"/>
            </a:xfrm>
          </p:grpSpPr>
          <p:pic>
            <p:nvPicPr>
              <p:cNvPr id="26" name="Picture 2" descr="E:\Shyamananda\eXPERIMENT\Western Chemi doc\2018\Shyama LDH A_p Threonin_serein_28022018\shyam LDH A_4 2018.02.28_09.25.51_Ch\shyam LDH A_4 2018.02.28_09.25.51_Ch+Marker.jpg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261" t="22555" r="22753" b="50044"/>
              <a:stretch/>
            </p:blipFill>
            <p:spPr bwMode="auto">
              <a:xfrm>
                <a:off x="7054523" y="3527629"/>
                <a:ext cx="1383538" cy="228237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30" name="TextBox 29"/>
              <p:cNvSpPr txBox="1"/>
              <p:nvPr/>
            </p:nvSpPr>
            <p:spPr>
              <a:xfrm>
                <a:off x="8401261" y="4735110"/>
                <a:ext cx="417720" cy="2581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DHA</a:t>
                </a:r>
              </a:p>
            </p:txBody>
          </p:sp>
        </p:grpSp>
        <p:grpSp>
          <p:nvGrpSpPr>
            <p:cNvPr id="38" name="Group 37"/>
            <p:cNvGrpSpPr/>
            <p:nvPr/>
          </p:nvGrpSpPr>
          <p:grpSpPr>
            <a:xfrm>
              <a:off x="126526" y="3929211"/>
              <a:ext cx="3269524" cy="2869072"/>
              <a:chOff x="4363379" y="1129123"/>
              <a:chExt cx="2449127" cy="2231133"/>
            </a:xfrm>
          </p:grpSpPr>
          <p:grpSp>
            <p:nvGrpSpPr>
              <p:cNvPr id="33" name="Group 32"/>
              <p:cNvGrpSpPr/>
              <p:nvPr/>
            </p:nvGrpSpPr>
            <p:grpSpPr>
              <a:xfrm>
                <a:off x="4744265" y="1129123"/>
                <a:ext cx="2068241" cy="2231133"/>
                <a:chOff x="4487254" y="654581"/>
                <a:chExt cx="2068241" cy="2137048"/>
              </a:xfrm>
            </p:grpSpPr>
            <p:pic>
              <p:nvPicPr>
                <p:cNvPr id="5" name="Picture 4" descr="E:\Shyamananda\eXPERIMENT\Western Chemi doc\2018\Shyam MCT 4 &amp; PCNA 27022018\shyam MCT4 1 2018.02.27_07.24.06_Ch\shyam MCT4 1 2018.02.27_07.24.06_Ch+Marker.jpg"/>
                <p:cNvPicPr/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2430" t="25961" r="26663" b="46649"/>
                <a:stretch/>
              </p:blipFill>
              <p:spPr bwMode="auto">
                <a:xfrm>
                  <a:off x="4487254" y="654581"/>
                  <a:ext cx="1611777" cy="21370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  <p:sp>
              <p:nvSpPr>
                <p:cNvPr id="9" name="TextBox 8"/>
                <p:cNvSpPr txBox="1"/>
                <p:nvPr/>
              </p:nvSpPr>
              <p:spPr>
                <a:xfrm>
                  <a:off x="6044475" y="1570079"/>
                  <a:ext cx="511020" cy="2428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CT-4</a:t>
                  </a:r>
                </a:p>
              </p:txBody>
            </p:sp>
          </p:grpSp>
          <p:sp>
            <p:nvSpPr>
              <p:cNvPr id="37" name="TextBox 36"/>
              <p:cNvSpPr txBox="1"/>
              <p:nvPr/>
            </p:nvSpPr>
            <p:spPr>
              <a:xfrm>
                <a:off x="4363379" y="1811263"/>
                <a:ext cx="402302" cy="25355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SA</a:t>
                </a:r>
              </a:p>
            </p:txBody>
          </p:sp>
        </p:grpSp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B52084B5-A48C-B37B-1F26-2770E2EE0AA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1433" r="8898" b="3711"/>
            <a:stretch/>
          </p:blipFill>
          <p:spPr>
            <a:xfrm>
              <a:off x="6557460" y="3913245"/>
              <a:ext cx="1964239" cy="2885320"/>
            </a:xfrm>
            <a:prstGeom prst="rect">
              <a:avLst/>
            </a:prstGeom>
          </p:spPr>
        </p:pic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F891505F-EB38-E9CC-A9DE-9D64EC00A7BF}"/>
                </a:ext>
              </a:extLst>
            </p:cNvPr>
            <p:cNvSpPr txBox="1"/>
            <p:nvPr/>
          </p:nvSpPr>
          <p:spPr>
            <a:xfrm>
              <a:off x="888331" y="3672776"/>
              <a:ext cx="1825540" cy="326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0      1     10    50   100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E4819FC2-3A5C-9F56-2BF0-BCF2DA7D54D1}"/>
                </a:ext>
              </a:extLst>
            </p:cNvPr>
            <p:cNvSpPr txBox="1"/>
            <p:nvPr/>
          </p:nvSpPr>
          <p:spPr>
            <a:xfrm>
              <a:off x="4009357" y="3576931"/>
              <a:ext cx="1779825" cy="326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0     1     10    50   100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8E38A17D-90E9-6755-645E-5BFA0C32FA39}"/>
                </a:ext>
              </a:extLst>
            </p:cNvPr>
            <p:cNvSpPr txBox="1"/>
            <p:nvPr/>
          </p:nvSpPr>
          <p:spPr>
            <a:xfrm>
              <a:off x="6718681" y="3611815"/>
              <a:ext cx="1734110" cy="326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0    1     10    50   100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3391275C-4B27-2109-3F4D-69DCD138D218}"/>
                </a:ext>
              </a:extLst>
            </p:cNvPr>
            <p:cNvSpPr txBox="1"/>
            <p:nvPr/>
          </p:nvSpPr>
          <p:spPr>
            <a:xfrm>
              <a:off x="4169446" y="3315969"/>
              <a:ext cx="1580105" cy="3622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HDL (ug/ml)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F02FC65A-BF3F-7E56-DEE3-87BC78BCA67C}"/>
                </a:ext>
              </a:extLst>
            </p:cNvPr>
            <p:cNvSpPr txBox="1"/>
            <p:nvPr/>
          </p:nvSpPr>
          <p:spPr>
            <a:xfrm>
              <a:off x="6941593" y="3380810"/>
              <a:ext cx="1580105" cy="3622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HDL (ug/ml)</a:t>
              </a:r>
            </a:p>
          </p:txBody>
        </p:sp>
      </p:grpSp>
      <p:grpSp>
        <p:nvGrpSpPr>
          <p:cNvPr id="44" name="Group 43">
            <a:extLst>
              <a:ext uri="{FF2B5EF4-FFF2-40B4-BE49-F238E27FC236}">
                <a16:creationId xmlns:a16="http://schemas.microsoft.com/office/drawing/2014/main" id="{A4098E6A-3131-B76E-3066-8F381267139F}"/>
              </a:ext>
            </a:extLst>
          </p:cNvPr>
          <p:cNvGrpSpPr/>
          <p:nvPr/>
        </p:nvGrpSpPr>
        <p:grpSpPr>
          <a:xfrm>
            <a:off x="2204444" y="78613"/>
            <a:ext cx="8582418" cy="2757943"/>
            <a:chOff x="192400" y="235847"/>
            <a:chExt cx="9064988" cy="3246372"/>
          </a:xfrm>
        </p:grpSpPr>
        <p:sp>
          <p:nvSpPr>
            <p:cNvPr id="8" name="TextBox 7"/>
            <p:cNvSpPr txBox="1"/>
            <p:nvPr/>
          </p:nvSpPr>
          <p:spPr>
            <a:xfrm>
              <a:off x="1340590" y="345502"/>
              <a:ext cx="1728641" cy="3622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LDL (ug/ml)</a:t>
              </a:r>
            </a:p>
          </p:txBody>
        </p:sp>
        <p:grpSp>
          <p:nvGrpSpPr>
            <p:cNvPr id="14" name="Group 13"/>
            <p:cNvGrpSpPr/>
            <p:nvPr/>
          </p:nvGrpSpPr>
          <p:grpSpPr>
            <a:xfrm>
              <a:off x="635000" y="568677"/>
              <a:ext cx="2769412" cy="2791381"/>
              <a:chOff x="363854" y="609980"/>
              <a:chExt cx="1454994" cy="1996301"/>
            </a:xfrm>
          </p:grpSpPr>
          <p:pic>
            <p:nvPicPr>
              <p:cNvPr id="4" name="Picture 3" descr="E:\Shyamananda\eXPERIMENT\Western Chemi doc\2018\Shyam MCT 4 &amp; PCNA 27022018\shyam MCT4 1 2018.02.27_07.24.06_Ch\shyam MCT4 1 2018.02.27_07.24.06_Ch+Marker.jpg"/>
              <p:cNvPicPr/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867" t="26477" r="47617" b="46670"/>
              <a:stretch/>
            </p:blipFill>
            <p:spPr bwMode="auto">
              <a:xfrm>
                <a:off x="363854" y="763948"/>
                <a:ext cx="1123117" cy="1842333"/>
              </a:xfrm>
              <a:prstGeom prst="rect">
                <a:avLst/>
              </a:prstGeom>
              <a:noFill/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sp>
            <p:nvSpPr>
              <p:cNvPr id="10" name="TextBox 9"/>
              <p:cNvSpPr txBox="1"/>
              <p:nvPr/>
            </p:nvSpPr>
            <p:spPr>
              <a:xfrm>
                <a:off x="1460434" y="1509578"/>
                <a:ext cx="358414" cy="23318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CT-4</a:t>
                </a: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625885" y="609980"/>
                <a:ext cx="887050" cy="23318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      1   10   50   100</a:t>
                </a:r>
              </a:p>
            </p:txBody>
          </p:sp>
        </p:grpSp>
        <p:sp>
          <p:nvSpPr>
            <p:cNvPr id="15" name="TextBox 14"/>
            <p:cNvSpPr txBox="1"/>
            <p:nvPr/>
          </p:nvSpPr>
          <p:spPr>
            <a:xfrm>
              <a:off x="8475840" y="1774765"/>
              <a:ext cx="781548" cy="326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  <p:grpSp>
          <p:nvGrpSpPr>
            <p:cNvPr id="31" name="Group 30"/>
            <p:cNvGrpSpPr/>
            <p:nvPr/>
          </p:nvGrpSpPr>
          <p:grpSpPr>
            <a:xfrm>
              <a:off x="3744822" y="726802"/>
              <a:ext cx="2718936" cy="2747641"/>
              <a:chOff x="2058826" y="3501984"/>
              <a:chExt cx="1839621" cy="2324114"/>
            </a:xfrm>
          </p:grpSpPr>
          <p:pic>
            <p:nvPicPr>
              <p:cNvPr id="27" name="Picture 2" descr="E:\Shyamananda\eXPERIMENT\Western Chemi doc\2018\Shyama LDH A_p Threonin_serein_28022018\shyam LDH A_4 2018.02.28_09.25.51_Ch\shyam LDH A_4 2018.02.28_09.25.51_Ch+Marker.jpg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024" t="22555" r="43839" b="48931"/>
              <a:stretch/>
            </p:blipFill>
            <p:spPr bwMode="auto">
              <a:xfrm>
                <a:off x="2058826" y="3501984"/>
                <a:ext cx="1446373" cy="232411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9" name="TextBox 28"/>
              <p:cNvSpPr txBox="1"/>
              <p:nvPr/>
            </p:nvSpPr>
            <p:spPr>
              <a:xfrm>
                <a:off x="3461756" y="4636130"/>
                <a:ext cx="436691" cy="27579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DHA</a:t>
                </a:r>
              </a:p>
            </p:txBody>
          </p:sp>
        </p:grpSp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FA6A45BC-FC7E-8C2B-FFBD-A9C6361449C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8502" t="5678"/>
            <a:stretch/>
          </p:blipFill>
          <p:spPr>
            <a:xfrm>
              <a:off x="6557460" y="694132"/>
              <a:ext cx="1964239" cy="2788087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9455891C-8474-6CD7-A3E9-F278783E6AE6}"/>
                </a:ext>
              </a:extLst>
            </p:cNvPr>
            <p:cNvSpPr txBox="1"/>
            <p:nvPr/>
          </p:nvSpPr>
          <p:spPr>
            <a:xfrm>
              <a:off x="4136692" y="501195"/>
              <a:ext cx="1779825" cy="326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0      1     10   50   100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9DC3B7AC-47A7-A2F6-C652-E8E1084E6115}"/>
                </a:ext>
              </a:extLst>
            </p:cNvPr>
            <p:cNvSpPr txBox="1"/>
            <p:nvPr/>
          </p:nvSpPr>
          <p:spPr>
            <a:xfrm>
              <a:off x="6966229" y="449804"/>
              <a:ext cx="1642681" cy="326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0    1    10   50   100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E2AF8D51-606B-0FB3-281D-EAF7F91AA769}"/>
                </a:ext>
              </a:extLst>
            </p:cNvPr>
            <p:cNvSpPr txBox="1"/>
            <p:nvPr/>
          </p:nvSpPr>
          <p:spPr>
            <a:xfrm>
              <a:off x="4447876" y="274056"/>
              <a:ext cx="1275426" cy="3622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LDL (ug/ml)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90B1BB6C-7F8F-B406-D671-C8069F9328D3}"/>
                </a:ext>
              </a:extLst>
            </p:cNvPr>
            <p:cNvSpPr txBox="1"/>
            <p:nvPr/>
          </p:nvSpPr>
          <p:spPr>
            <a:xfrm>
              <a:off x="7178420" y="235847"/>
              <a:ext cx="1275426" cy="3622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LDL (ug/ml)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24AB9EF8-DB3B-128A-33C2-132BEE13F91B}"/>
                </a:ext>
              </a:extLst>
            </p:cNvPr>
            <p:cNvSpPr txBox="1"/>
            <p:nvPr/>
          </p:nvSpPr>
          <p:spPr>
            <a:xfrm>
              <a:off x="192400" y="1497765"/>
              <a:ext cx="537063" cy="326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SA</a:t>
              </a:r>
            </a:p>
          </p:txBody>
        </p:sp>
      </p:grpSp>
      <p:sp>
        <p:nvSpPr>
          <p:cNvPr id="46" name="TextBox 45">
            <a:extLst>
              <a:ext uri="{FF2B5EF4-FFF2-40B4-BE49-F238E27FC236}">
                <a16:creationId xmlns:a16="http://schemas.microsoft.com/office/drawing/2014/main" id="{DC619D8A-941D-BAC9-C8D1-A5483D22652D}"/>
              </a:ext>
            </a:extLst>
          </p:cNvPr>
          <p:cNvSpPr txBox="1"/>
          <p:nvPr/>
        </p:nvSpPr>
        <p:spPr>
          <a:xfrm>
            <a:off x="28115" y="-32441"/>
            <a:ext cx="1954615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6.D. : MCT-4, LDHA, </a:t>
            </a:r>
          </a:p>
          <a:p>
            <a:pPr algn="just"/>
            <a:r>
              <a:rPr lang="el-GR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Actin and  GAPDH Whole blot</a:t>
            </a:r>
            <a:endParaRPr lang="en-I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DF6FEDC9-A70E-D09F-A871-86A9640A8B02}"/>
              </a:ext>
            </a:extLst>
          </p:cNvPr>
          <p:cNvCxnSpPr>
            <a:cxnSpLocks/>
          </p:cNvCxnSpPr>
          <p:nvPr/>
        </p:nvCxnSpPr>
        <p:spPr>
          <a:xfrm>
            <a:off x="3355960" y="2943904"/>
            <a:ext cx="6274423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86D98953-DD2F-8D97-8FD4-0624D34EF277}"/>
              </a:ext>
            </a:extLst>
          </p:cNvPr>
          <p:cNvSpPr txBox="1"/>
          <p:nvPr/>
        </p:nvSpPr>
        <p:spPr>
          <a:xfrm>
            <a:off x="5755197" y="2909695"/>
            <a:ext cx="17908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-probed for LDHA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7DEC706-416D-AF06-DF86-72D79211D77B}"/>
              </a:ext>
            </a:extLst>
          </p:cNvPr>
          <p:cNvSpPr txBox="1"/>
          <p:nvPr/>
        </p:nvSpPr>
        <p:spPr>
          <a:xfrm>
            <a:off x="8299521" y="2926964"/>
            <a:ext cx="17908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-probed for 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C158E515-FFDB-C67E-33B0-8B2A6AE34682}"/>
              </a:ext>
            </a:extLst>
          </p:cNvPr>
          <p:cNvCxnSpPr>
            <a:cxnSpLocks/>
          </p:cNvCxnSpPr>
          <p:nvPr/>
        </p:nvCxnSpPr>
        <p:spPr>
          <a:xfrm>
            <a:off x="3355960" y="2943166"/>
            <a:ext cx="6274423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4E3AD1D0-C280-FAA5-036D-F159E814487C}"/>
              </a:ext>
            </a:extLst>
          </p:cNvPr>
          <p:cNvSpPr txBox="1"/>
          <p:nvPr/>
        </p:nvSpPr>
        <p:spPr>
          <a:xfrm>
            <a:off x="2357866" y="2821796"/>
            <a:ext cx="11568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ame blots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33E39277-72E8-D709-9488-0BA96E0163CC}"/>
              </a:ext>
            </a:extLst>
          </p:cNvPr>
          <p:cNvSpPr txBox="1"/>
          <p:nvPr/>
        </p:nvSpPr>
        <p:spPr>
          <a:xfrm>
            <a:off x="8296767" y="6389728"/>
            <a:ext cx="1859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-probed for GAPDH 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EB7F23A4-F4F3-B921-8C82-6EF3E11A0AF7}"/>
              </a:ext>
            </a:extLst>
          </p:cNvPr>
          <p:cNvCxnSpPr>
            <a:cxnSpLocks/>
          </p:cNvCxnSpPr>
          <p:nvPr/>
        </p:nvCxnSpPr>
        <p:spPr>
          <a:xfrm>
            <a:off x="3514667" y="6387642"/>
            <a:ext cx="6274423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C11488D3-0E34-981F-87D5-5FD6F631D337}"/>
              </a:ext>
            </a:extLst>
          </p:cNvPr>
          <p:cNvSpPr txBox="1"/>
          <p:nvPr/>
        </p:nvSpPr>
        <p:spPr>
          <a:xfrm>
            <a:off x="2520750" y="6241934"/>
            <a:ext cx="11498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ame blots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DE3E3B0D-3D79-88D7-F7B4-CCB1E930181A}"/>
              </a:ext>
            </a:extLst>
          </p:cNvPr>
          <p:cNvSpPr txBox="1"/>
          <p:nvPr/>
        </p:nvSpPr>
        <p:spPr>
          <a:xfrm>
            <a:off x="5913905" y="6353433"/>
            <a:ext cx="17369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-probed for LDHA </a:t>
            </a:r>
          </a:p>
        </p:txBody>
      </p:sp>
    </p:spTree>
    <p:extLst>
      <p:ext uri="{BB962C8B-B14F-4D97-AF65-F5344CB8AC3E}">
        <p14:creationId xmlns:p14="http://schemas.microsoft.com/office/powerpoint/2010/main" val="77172694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1740A063-C50A-736D-7DFB-0EEB44F7581E}"/>
              </a:ext>
            </a:extLst>
          </p:cNvPr>
          <p:cNvSpPr txBox="1"/>
          <p:nvPr/>
        </p:nvSpPr>
        <p:spPr>
          <a:xfrm>
            <a:off x="92580" y="120748"/>
            <a:ext cx="61916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6.D. : MCT-1, MCT-2, and  </a:t>
            </a:r>
            <a:r>
              <a:rPr lang="el-GR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 Whole blot</a:t>
            </a:r>
            <a:endParaRPr lang="en-I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1115261D-6694-E7BB-56E2-323D103F9535}"/>
              </a:ext>
            </a:extLst>
          </p:cNvPr>
          <p:cNvGrpSpPr/>
          <p:nvPr/>
        </p:nvGrpSpPr>
        <p:grpSpPr>
          <a:xfrm>
            <a:off x="3761110" y="1043006"/>
            <a:ext cx="3030667" cy="4385185"/>
            <a:chOff x="1231411" y="1383303"/>
            <a:chExt cx="3030667" cy="4385185"/>
          </a:xfrm>
        </p:grpSpPr>
        <p:pic>
          <p:nvPicPr>
            <p:cNvPr id="17" name="Picture 16"/>
            <p:cNvPicPr>
              <a:picLocks noChangeAspect="1"/>
            </p:cNvPicPr>
            <p:nvPr/>
          </p:nvPicPr>
          <p:blipFill rotWithShape="1">
            <a:blip r:embed="rId2"/>
            <a:srcRect l="12649" t="28014" r="66865" b="24230"/>
            <a:stretch/>
          </p:blipFill>
          <p:spPr>
            <a:xfrm>
              <a:off x="1231411" y="1698537"/>
              <a:ext cx="1951715" cy="3771591"/>
            </a:xfrm>
            <a:prstGeom prst="rect">
              <a:avLst/>
            </a:prstGeom>
          </p:spPr>
        </p:pic>
        <p:sp>
          <p:nvSpPr>
            <p:cNvPr id="21" name="TextBox 20"/>
            <p:cNvSpPr txBox="1"/>
            <p:nvPr/>
          </p:nvSpPr>
          <p:spPr>
            <a:xfrm>
              <a:off x="3116661" y="3011711"/>
              <a:ext cx="114541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β-Tubulin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7EFD11E7-237E-3215-715C-8348EE55D494}"/>
                </a:ext>
              </a:extLst>
            </p:cNvPr>
            <p:cNvSpPr txBox="1"/>
            <p:nvPr/>
          </p:nvSpPr>
          <p:spPr>
            <a:xfrm>
              <a:off x="1717561" y="5429934"/>
              <a:ext cx="113128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β-Tubulin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394702" y="1383303"/>
              <a:ext cx="21287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100" dirty="0">
                  <a:latin typeface="Arial" panose="020B0604020202020204" pitchFamily="34" charset="0"/>
                  <a:cs typeface="Arial" panose="020B0604020202020204" pitchFamily="34" charset="0"/>
                </a:rPr>
                <a:t> LDL(ug/ml)   HDL(ug/ml)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6C62D221-60B4-7B2E-93C2-2E59EC5E7FF3}"/>
                </a:ext>
              </a:extLst>
            </p:cNvPr>
            <p:cNvSpPr txBox="1"/>
            <p:nvPr/>
          </p:nvSpPr>
          <p:spPr>
            <a:xfrm>
              <a:off x="1535654" y="1603126"/>
              <a:ext cx="1493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  0     50     0     50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F10A12EE-7E2C-DD0B-C775-4C4504DFE34A}"/>
              </a:ext>
            </a:extLst>
          </p:cNvPr>
          <p:cNvGrpSpPr/>
          <p:nvPr/>
        </p:nvGrpSpPr>
        <p:grpSpPr>
          <a:xfrm>
            <a:off x="9069676" y="962035"/>
            <a:ext cx="2977246" cy="4399912"/>
            <a:chOff x="297737" y="1507374"/>
            <a:chExt cx="2977246" cy="4399912"/>
          </a:xfrm>
        </p:grpSpPr>
        <p:pic>
          <p:nvPicPr>
            <p:cNvPr id="18" name="Picture 17"/>
            <p:cNvPicPr>
              <a:picLocks noChangeAspect="1"/>
            </p:cNvPicPr>
            <p:nvPr/>
          </p:nvPicPr>
          <p:blipFill rotWithShape="1">
            <a:blip r:embed="rId3"/>
            <a:srcRect l="66876" t="3816" r="3733" b="3698"/>
            <a:stretch/>
          </p:blipFill>
          <p:spPr>
            <a:xfrm>
              <a:off x="297737" y="1839782"/>
              <a:ext cx="1890513" cy="3784591"/>
            </a:xfrm>
            <a:prstGeom prst="rect">
              <a:avLst/>
            </a:prstGeom>
          </p:spPr>
        </p:pic>
        <p:sp>
          <p:nvSpPr>
            <p:cNvPr id="22" name="TextBox 21"/>
            <p:cNvSpPr txBox="1"/>
            <p:nvPr/>
          </p:nvSpPr>
          <p:spPr>
            <a:xfrm>
              <a:off x="2188250" y="3138304"/>
              <a:ext cx="108673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β-Tubulin</a:t>
              </a:r>
            </a:p>
          </p:txBody>
        </p:sp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41615220-4183-558C-E3E3-D6692E3D67D7}"/>
                </a:ext>
              </a:extLst>
            </p:cNvPr>
            <p:cNvGrpSpPr/>
            <p:nvPr/>
          </p:nvGrpSpPr>
          <p:grpSpPr>
            <a:xfrm>
              <a:off x="368705" y="1507374"/>
              <a:ext cx="2228795" cy="521858"/>
              <a:chOff x="1097423" y="1303496"/>
              <a:chExt cx="2128791" cy="493944"/>
            </a:xfrm>
          </p:grpSpPr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0F8D8D75-F600-B589-3ECB-1E8B1CCEEAED}"/>
                  </a:ext>
                </a:extLst>
              </p:cNvPr>
              <p:cNvSpPr txBox="1"/>
              <p:nvPr/>
            </p:nvSpPr>
            <p:spPr>
              <a:xfrm>
                <a:off x="1097423" y="1303496"/>
                <a:ext cx="2128791" cy="2476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LDL(ug/ml)   HDL(ug/ml)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17CFF1BC-7A5F-DEA9-0173-A39381C7F69C}"/>
                  </a:ext>
                </a:extLst>
              </p:cNvPr>
              <p:cNvSpPr txBox="1"/>
              <p:nvPr/>
            </p:nvSpPr>
            <p:spPr>
              <a:xfrm>
                <a:off x="1244406" y="1535258"/>
                <a:ext cx="1493016" cy="2621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0     50       0     50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5DFEBEA6-E4FD-C754-F25E-001D8AAAA62B}"/>
                </a:ext>
              </a:extLst>
            </p:cNvPr>
            <p:cNvSpPr txBox="1"/>
            <p:nvPr/>
          </p:nvSpPr>
          <p:spPr>
            <a:xfrm>
              <a:off x="760803" y="5537954"/>
              <a:ext cx="124174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800" dirty="0">
                  <a:latin typeface="Arial" panose="020B0604020202020204" pitchFamily="34" charset="0"/>
                  <a:cs typeface="Arial" panose="020B0604020202020204" pitchFamily="34" charset="0"/>
                </a:rPr>
                <a:t>-Tubulin</a:t>
              </a:r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1022F912-A9B5-0EE8-40CB-C88F7B3FFAAE}"/>
              </a:ext>
            </a:extLst>
          </p:cNvPr>
          <p:cNvGrpSpPr/>
          <p:nvPr/>
        </p:nvGrpSpPr>
        <p:grpSpPr>
          <a:xfrm>
            <a:off x="6688072" y="962036"/>
            <a:ext cx="2554966" cy="4381549"/>
            <a:chOff x="3832131" y="1488589"/>
            <a:chExt cx="2554966" cy="4381549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490" t="30108" r="31009" b="25049"/>
            <a:stretch/>
          </p:blipFill>
          <p:spPr>
            <a:xfrm>
              <a:off x="3832131" y="1952196"/>
              <a:ext cx="1702449" cy="3646303"/>
            </a:xfrm>
            <a:prstGeom prst="rect">
              <a:avLst/>
            </a:prstGeom>
          </p:spPr>
        </p:pic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6311688C-A793-02E0-3514-6AF36BDCEE2C}"/>
                </a:ext>
              </a:extLst>
            </p:cNvPr>
            <p:cNvGrpSpPr/>
            <p:nvPr/>
          </p:nvGrpSpPr>
          <p:grpSpPr>
            <a:xfrm>
              <a:off x="3875259" y="1488589"/>
              <a:ext cx="2228795" cy="521859"/>
              <a:chOff x="1097423" y="1303496"/>
              <a:chExt cx="2128791" cy="493944"/>
            </a:xfrm>
          </p:grpSpPr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A981B93D-3646-84C8-E803-A021A4C4B66D}"/>
                  </a:ext>
                </a:extLst>
              </p:cNvPr>
              <p:cNvSpPr txBox="1"/>
              <p:nvPr/>
            </p:nvSpPr>
            <p:spPr>
              <a:xfrm>
                <a:off x="1097423" y="1303496"/>
                <a:ext cx="2128791" cy="2476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LDL(ug/ml)   HDL(ug/ml)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B18EEC1E-AC70-3030-AF5B-7EEE747F1CBC}"/>
                  </a:ext>
                </a:extLst>
              </p:cNvPr>
              <p:cNvSpPr txBox="1"/>
              <p:nvPr/>
            </p:nvSpPr>
            <p:spPr>
              <a:xfrm>
                <a:off x="1244406" y="1535258"/>
                <a:ext cx="1493016" cy="2621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0     50     0     50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90EF306E-4752-447B-3641-15917FF0DE5C}"/>
                </a:ext>
              </a:extLst>
            </p:cNvPr>
            <p:cNvSpPr txBox="1"/>
            <p:nvPr/>
          </p:nvSpPr>
          <p:spPr>
            <a:xfrm>
              <a:off x="5474152" y="3475880"/>
              <a:ext cx="91294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600" dirty="0">
                  <a:latin typeface="Arial" panose="020B0604020202020204" pitchFamily="34" charset="0"/>
                  <a:cs typeface="Arial" panose="020B0604020202020204" pitchFamily="34" charset="0"/>
                </a:rPr>
                <a:t>MCT2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B93257EF-6326-359C-2D79-997CBBE7F3A7}"/>
                </a:ext>
              </a:extLst>
            </p:cNvPr>
            <p:cNvSpPr txBox="1"/>
            <p:nvPr/>
          </p:nvSpPr>
          <p:spPr>
            <a:xfrm>
              <a:off x="4354251" y="5500806"/>
              <a:ext cx="91294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dirty="0">
                  <a:latin typeface="Arial" panose="020B0604020202020204" pitchFamily="34" charset="0"/>
                  <a:cs typeface="Arial" panose="020B0604020202020204" pitchFamily="34" charset="0"/>
                </a:rPr>
                <a:t>MCT2</a:t>
              </a:r>
            </a:p>
          </p:txBody>
        </p: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2CB0C69D-EB3A-2AA1-D0F8-E0FE009CAB2F}"/>
              </a:ext>
            </a:extLst>
          </p:cNvPr>
          <p:cNvGrpSpPr/>
          <p:nvPr/>
        </p:nvGrpSpPr>
        <p:grpSpPr>
          <a:xfrm>
            <a:off x="1131325" y="1043006"/>
            <a:ext cx="2784644" cy="4383692"/>
            <a:chOff x="3911700" y="1371365"/>
            <a:chExt cx="2784644" cy="4383692"/>
          </a:xfrm>
        </p:grpSpPr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5CFC21AC-2010-D9D5-B8DE-683569C06A4C}"/>
                </a:ext>
              </a:extLst>
            </p:cNvPr>
            <p:cNvSpPr txBox="1"/>
            <p:nvPr/>
          </p:nvSpPr>
          <p:spPr>
            <a:xfrm>
              <a:off x="5824362" y="3552502"/>
              <a:ext cx="87198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600" dirty="0">
                  <a:latin typeface="Arial" panose="020B0604020202020204" pitchFamily="34" charset="0"/>
                  <a:cs typeface="Arial" panose="020B0604020202020204" pitchFamily="34" charset="0"/>
                </a:rPr>
                <a:t>MCT1</a:t>
              </a:r>
            </a:p>
          </p:txBody>
        </p:sp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894" t="30060" r="51857" b="21666"/>
            <a:stretch/>
          </p:blipFill>
          <p:spPr>
            <a:xfrm>
              <a:off x="3911700" y="1644913"/>
              <a:ext cx="1980821" cy="3771590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4466119" y="5416503"/>
              <a:ext cx="87198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600" dirty="0">
                  <a:latin typeface="Arial" panose="020B0604020202020204" pitchFamily="34" charset="0"/>
                  <a:cs typeface="Arial" panose="020B0604020202020204" pitchFamily="34" charset="0"/>
                </a:rPr>
                <a:t>MCT1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5B60F0A5-5034-21B3-6AB8-6960BB294BAC}"/>
                </a:ext>
              </a:extLst>
            </p:cNvPr>
            <p:cNvSpPr txBox="1"/>
            <p:nvPr/>
          </p:nvSpPr>
          <p:spPr>
            <a:xfrm>
              <a:off x="4131562" y="1371365"/>
              <a:ext cx="21287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100" dirty="0">
                  <a:latin typeface="Arial" panose="020B0604020202020204" pitchFamily="34" charset="0"/>
                  <a:cs typeface="Arial" panose="020B0604020202020204" pitchFamily="34" charset="0"/>
                </a:rPr>
                <a:t> LDL(ug/ml)   HDL(ug/ml)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11023510-6130-C462-5081-07B0D326798C}"/>
                </a:ext>
              </a:extLst>
            </p:cNvPr>
            <p:cNvSpPr txBox="1"/>
            <p:nvPr/>
          </p:nvSpPr>
          <p:spPr>
            <a:xfrm>
              <a:off x="4278545" y="1603127"/>
              <a:ext cx="1493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0     50     0     50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03E75A3-3D10-EAE4-39E7-8B17D658AE77}"/>
                </a:ext>
              </a:extLst>
            </p:cNvPr>
            <p:cNvSpPr txBox="1"/>
            <p:nvPr/>
          </p:nvSpPr>
          <p:spPr>
            <a:xfrm>
              <a:off x="5824362" y="3556693"/>
              <a:ext cx="87198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600" dirty="0">
                  <a:latin typeface="Arial" panose="020B0604020202020204" pitchFamily="34" charset="0"/>
                  <a:cs typeface="Arial" panose="020B0604020202020204" pitchFamily="34" charset="0"/>
                </a:rPr>
                <a:t>MCT1</a:t>
              </a:r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D0E1F25E-7549-AAB3-0E50-E8F0C9983CC8}"/>
              </a:ext>
            </a:extLst>
          </p:cNvPr>
          <p:cNvSpPr txBox="1"/>
          <p:nvPr/>
        </p:nvSpPr>
        <p:spPr>
          <a:xfrm>
            <a:off x="575449" y="2503560"/>
            <a:ext cx="6111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dirty="0">
                <a:latin typeface="Arial" panose="020B0604020202020204" pitchFamily="34" charset="0"/>
                <a:cs typeface="Arial" panose="020B0604020202020204" pitchFamily="34" charset="0"/>
              </a:rPr>
              <a:t>BS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DCB9AEE-31FB-FF0C-1ACD-086B5BCD656F}"/>
              </a:ext>
            </a:extLst>
          </p:cNvPr>
          <p:cNvSpPr txBox="1"/>
          <p:nvPr/>
        </p:nvSpPr>
        <p:spPr>
          <a:xfrm>
            <a:off x="38287" y="3044049"/>
            <a:ext cx="12301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dirty="0">
                <a:latin typeface="Arial" panose="020B0604020202020204" pitchFamily="34" charset="0"/>
                <a:cs typeface="Arial" panose="020B0604020202020204" pitchFamily="34" charset="0"/>
              </a:rPr>
              <a:t>Ovalbumin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089A5D37-2368-2CC9-F973-EB56B78D341E}"/>
              </a:ext>
            </a:extLst>
          </p:cNvPr>
          <p:cNvCxnSpPr>
            <a:cxnSpLocks/>
          </p:cNvCxnSpPr>
          <p:nvPr/>
        </p:nvCxnSpPr>
        <p:spPr>
          <a:xfrm>
            <a:off x="1814248" y="5538125"/>
            <a:ext cx="3564294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045A75AC-83E3-612C-FD39-7391FF20BD2A}"/>
              </a:ext>
            </a:extLst>
          </p:cNvPr>
          <p:cNvSpPr txBox="1"/>
          <p:nvPr/>
        </p:nvSpPr>
        <p:spPr>
          <a:xfrm>
            <a:off x="808845" y="5382699"/>
            <a:ext cx="10054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ame blots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523FBD2-7598-836F-6E67-D80774F5FA2A}"/>
              </a:ext>
            </a:extLst>
          </p:cNvPr>
          <p:cNvSpPr txBox="1"/>
          <p:nvPr/>
        </p:nvSpPr>
        <p:spPr>
          <a:xfrm>
            <a:off x="3856672" y="5559486"/>
            <a:ext cx="19397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-probed for 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B22A1CAD-139B-F40F-FE46-0CFF258095F6}"/>
              </a:ext>
            </a:extLst>
          </p:cNvPr>
          <p:cNvCxnSpPr>
            <a:cxnSpLocks/>
          </p:cNvCxnSpPr>
          <p:nvPr/>
        </p:nvCxnSpPr>
        <p:spPr>
          <a:xfrm>
            <a:off x="7098220" y="5512446"/>
            <a:ext cx="3564294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C0EC1477-CBA8-F4E9-F6D3-CED27944296D}"/>
              </a:ext>
            </a:extLst>
          </p:cNvPr>
          <p:cNvSpPr txBox="1"/>
          <p:nvPr/>
        </p:nvSpPr>
        <p:spPr>
          <a:xfrm>
            <a:off x="6092817" y="5357020"/>
            <a:ext cx="10054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ame blots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E6F5AE4-D703-928D-E116-056A5FEF127F}"/>
              </a:ext>
            </a:extLst>
          </p:cNvPr>
          <p:cNvSpPr txBox="1"/>
          <p:nvPr/>
        </p:nvSpPr>
        <p:spPr>
          <a:xfrm>
            <a:off x="9140644" y="5533717"/>
            <a:ext cx="19830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-probed for 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Tubulin </a:t>
            </a:r>
          </a:p>
        </p:txBody>
      </p:sp>
    </p:spTree>
    <p:extLst>
      <p:ext uri="{BB962C8B-B14F-4D97-AF65-F5344CB8AC3E}">
        <p14:creationId xmlns:p14="http://schemas.microsoft.com/office/powerpoint/2010/main" val="23826483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6</TotalTime>
  <Words>571</Words>
  <Application>Microsoft Office PowerPoint</Application>
  <PresentationFormat>Widescreen</PresentationFormat>
  <Paragraphs>14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yamananda Mayengbam</dc:creator>
  <cp:lastModifiedBy>ABHIJEET SINGH</cp:lastModifiedBy>
  <cp:revision>26</cp:revision>
  <dcterms:created xsi:type="dcterms:W3CDTF">2022-12-06T05:38:46Z</dcterms:created>
  <dcterms:modified xsi:type="dcterms:W3CDTF">2022-12-23T11:21:40Z</dcterms:modified>
</cp:coreProperties>
</file>